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diagrams/colors1.xml" ContentType="application/vnd.openxmlformats-officedocument.drawingml.diagramColor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Override PartName="/ppt/diagrams/quickStyle1.xml" ContentType="application/vnd.openxmlformats-officedocument.drawingml.diagramStyle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diagrams/layout1.xml" ContentType="application/vnd.openxmlformats-officedocument.drawingml.diagram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diagrams/data1.xml" ContentType="application/vnd.openxmlformats-officedocument.drawingml.diagramData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44" r:id="rId1"/>
  </p:sldMasterIdLst>
  <p:notesMasterIdLst>
    <p:notesMasterId r:id="rId3"/>
  </p:notesMasterIdLst>
  <p:sldIdLst>
    <p:sldId id="256" r:id="rId2"/>
  </p:sldIdLst>
  <p:sldSz cx="6483350" cy="3602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4E4E4"/>
    <a:srgbClr val="D5D9EE"/>
    <a:srgbClr val="B2BCE2"/>
    <a:srgbClr val="E5E8F6"/>
    <a:srgbClr val="FFFFFF"/>
    <a:srgbClr val="223061"/>
    <a:srgbClr val="D9D9D9"/>
    <a:srgbClr val="E3E9E9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9530"/>
    <p:restoredTop sz="99855" autoAdjust="0"/>
  </p:normalViewPr>
  <p:slideViewPr>
    <p:cSldViewPr snapToGrid="0" snapToObjects="1">
      <p:cViewPr>
        <p:scale>
          <a:sx n="160" d="100"/>
          <a:sy n="160" d="100"/>
        </p:scale>
        <p:origin x="-858" y="-246"/>
      </p:cViewPr>
      <p:guideLst>
        <p:guide orient="horz" pos="1134"/>
        <p:guide pos="20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5_1">
  <dgm:title val=""/>
  <dgm:desc val=""/>
  <dgm:catLst>
    <dgm:cat type="accent5" pri="11100"/>
  </dgm:catLst>
  <dgm:styleLbl name="node0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5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5">
        <a:tint val="4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5">
        <a:tint val="4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5">
        <a:tint val="4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5"/>
    </dgm:fillClrLst>
    <dgm:linClrLst meth="repeat">
      <a:schemeClr val="accent5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accent5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5"/>
    </dgm:fillClrLst>
    <dgm:linClrLst meth="repeat">
      <a:schemeClr val="accent5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5"/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/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5">
        <a:alpha val="4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5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5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5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5">
        <a:alpha val="90000"/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8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97444FA-EBAB-4344-BCAA-AD1EDCF18D56}" type="doc">
      <dgm:prSet loTypeId="urn:microsoft.com/office/officeart/2005/8/layout/hierarchy2" loCatId="hierarchy" qsTypeId="urn:microsoft.com/office/officeart/2005/8/quickstyle/simple4" qsCatId="simple" csTypeId="urn:microsoft.com/office/officeart/2005/8/colors/accent5_1" csCatId="accent5" phldr="1"/>
      <dgm:spPr/>
      <dgm:t>
        <a:bodyPr/>
        <a:lstStyle/>
        <a:p>
          <a:endParaRPr lang="en-GB"/>
        </a:p>
      </dgm:t>
    </dgm:pt>
    <dgm:pt modelId="{D9BC3921-C5C6-46C2-928A-8519CF085E50}">
      <dgm:prSet phldrT="[Texto]"/>
      <dgm:spPr/>
      <dgm:t>
        <a:bodyPr/>
        <a:lstStyle/>
        <a:p>
          <a:r>
            <a:rPr lang="es-ES" smtClean="0"/>
            <a:t>200 first CDI</a:t>
          </a:r>
          <a:endParaRPr lang="en-GB" dirty="0"/>
        </a:p>
      </dgm:t>
    </dgm:pt>
    <dgm:pt modelId="{B6F44240-2E25-449E-BFC5-AD11AABC8461}" type="parTrans" cxnId="{F5C62860-4225-44B7-A3FE-CCB76032FBE1}">
      <dgm:prSet/>
      <dgm:spPr/>
      <dgm:t>
        <a:bodyPr/>
        <a:lstStyle/>
        <a:p>
          <a:endParaRPr lang="en-GB"/>
        </a:p>
      </dgm:t>
    </dgm:pt>
    <dgm:pt modelId="{91CD3A84-80D6-4A0A-B036-E923D3C2D679}" type="sibTrans" cxnId="{F5C62860-4225-44B7-A3FE-CCB76032FBE1}">
      <dgm:prSet/>
      <dgm:spPr/>
      <dgm:t>
        <a:bodyPr/>
        <a:lstStyle/>
        <a:p>
          <a:endParaRPr lang="en-GB"/>
        </a:p>
      </dgm:t>
    </dgm:pt>
    <dgm:pt modelId="{876020D4-47BB-49EB-A02C-EC2DE430D0F2}">
      <dgm:prSet phldrT="[Texto]"/>
      <dgm:spPr/>
      <dgm:t>
        <a:bodyPr/>
        <a:lstStyle/>
        <a:p>
          <a:r>
            <a:rPr lang="es-ES" smtClean="0"/>
            <a:t>RCDI 54</a:t>
          </a:r>
          <a:endParaRPr lang="en-GB" dirty="0"/>
        </a:p>
      </dgm:t>
    </dgm:pt>
    <dgm:pt modelId="{CBE5E49E-BB02-47F1-9894-1EECB620F7A1}" type="parTrans" cxnId="{09C3C676-E85F-4384-98DA-EAFD39523E07}">
      <dgm:prSet/>
      <dgm:spPr/>
      <dgm:t>
        <a:bodyPr/>
        <a:lstStyle/>
        <a:p>
          <a:endParaRPr lang="en-GB"/>
        </a:p>
      </dgm:t>
    </dgm:pt>
    <dgm:pt modelId="{344C9FCE-46B7-4224-8C78-90759D5A61B0}" type="sibTrans" cxnId="{09C3C676-E85F-4384-98DA-EAFD39523E07}">
      <dgm:prSet/>
      <dgm:spPr/>
      <dgm:t>
        <a:bodyPr/>
        <a:lstStyle/>
        <a:p>
          <a:endParaRPr lang="en-GB"/>
        </a:p>
      </dgm:t>
    </dgm:pt>
    <dgm:pt modelId="{421D37E8-DF8B-40A2-A3A9-5880088563E1}">
      <dgm:prSet phldrT="[Texto]"/>
      <dgm:spPr/>
      <dgm:t>
        <a:bodyPr/>
        <a:lstStyle/>
        <a:p>
          <a:r>
            <a:rPr lang="es-ES" smtClean="0"/>
            <a:t>Non-RCDI 146</a:t>
          </a:r>
          <a:endParaRPr lang="en-GB" dirty="0"/>
        </a:p>
      </dgm:t>
    </dgm:pt>
    <dgm:pt modelId="{FE09D7EF-4568-4064-861F-D65552ACA096}" type="parTrans" cxnId="{EC525CED-F53D-472C-9561-1E7A20681C01}">
      <dgm:prSet/>
      <dgm:spPr/>
      <dgm:t>
        <a:bodyPr/>
        <a:lstStyle/>
        <a:p>
          <a:endParaRPr lang="en-GB"/>
        </a:p>
      </dgm:t>
    </dgm:pt>
    <dgm:pt modelId="{A1CFE19D-B289-4F8A-8338-2F3DA5841785}" type="sibTrans" cxnId="{EC525CED-F53D-472C-9561-1E7A20681C01}">
      <dgm:prSet/>
      <dgm:spPr/>
      <dgm:t>
        <a:bodyPr/>
        <a:lstStyle/>
        <a:p>
          <a:endParaRPr lang="en-GB"/>
        </a:p>
      </dgm:t>
    </dgm:pt>
    <dgm:pt modelId="{29FCF24C-2DE6-4D86-98D9-87524F46A1E2}" type="pres">
      <dgm:prSet presAssocID="{197444FA-EBAB-4344-BCAA-AD1EDCF18D56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  <dgm:t>
        <a:bodyPr/>
        <a:lstStyle/>
        <a:p>
          <a:endParaRPr lang="en-GB"/>
        </a:p>
      </dgm:t>
    </dgm:pt>
    <dgm:pt modelId="{2BD1E0AA-6F23-4818-9DAF-6F48FE6AB948}" type="pres">
      <dgm:prSet presAssocID="{D9BC3921-C5C6-46C2-928A-8519CF085E50}" presName="root1" presStyleCnt="0"/>
      <dgm:spPr/>
    </dgm:pt>
    <dgm:pt modelId="{A7811A13-B682-4B70-A412-512B711BF07F}" type="pres">
      <dgm:prSet presAssocID="{D9BC3921-C5C6-46C2-928A-8519CF085E50}" presName="LevelOneTextNode" presStyleLbl="node0" presStyleIdx="0" presStyleCnt="1">
        <dgm:presLayoutVars>
          <dgm:chPref val="3"/>
        </dgm:presLayoutVars>
      </dgm:prSet>
      <dgm:spPr/>
      <dgm:t>
        <a:bodyPr/>
        <a:lstStyle/>
        <a:p>
          <a:endParaRPr lang="en-GB"/>
        </a:p>
      </dgm:t>
    </dgm:pt>
    <dgm:pt modelId="{B129C3B7-4FD9-417B-B8A2-96AC41D41E4D}" type="pres">
      <dgm:prSet presAssocID="{D9BC3921-C5C6-46C2-928A-8519CF085E50}" presName="level2hierChild" presStyleCnt="0"/>
      <dgm:spPr/>
    </dgm:pt>
    <dgm:pt modelId="{F3A97E10-34EE-4BBB-B629-42D0E6AD301C}" type="pres">
      <dgm:prSet presAssocID="{FE09D7EF-4568-4064-861F-D65552ACA096}" presName="conn2-1" presStyleLbl="parChTrans1D2" presStyleIdx="0" presStyleCnt="2"/>
      <dgm:spPr/>
      <dgm:t>
        <a:bodyPr/>
        <a:lstStyle/>
        <a:p>
          <a:endParaRPr lang="en-GB"/>
        </a:p>
      </dgm:t>
    </dgm:pt>
    <dgm:pt modelId="{406F40F1-90D9-48A9-B27E-72FB00422106}" type="pres">
      <dgm:prSet presAssocID="{FE09D7EF-4568-4064-861F-D65552ACA096}" presName="connTx" presStyleLbl="parChTrans1D2" presStyleIdx="0" presStyleCnt="2"/>
      <dgm:spPr/>
      <dgm:t>
        <a:bodyPr/>
        <a:lstStyle/>
        <a:p>
          <a:endParaRPr lang="en-GB"/>
        </a:p>
      </dgm:t>
    </dgm:pt>
    <dgm:pt modelId="{8A0858B8-7766-492F-A40E-068658E8D063}" type="pres">
      <dgm:prSet presAssocID="{421D37E8-DF8B-40A2-A3A9-5880088563E1}" presName="root2" presStyleCnt="0"/>
      <dgm:spPr/>
    </dgm:pt>
    <dgm:pt modelId="{3F75941D-CC1C-4EA3-8A1F-EB8F3E8800EA}" type="pres">
      <dgm:prSet presAssocID="{421D37E8-DF8B-40A2-A3A9-5880088563E1}" presName="LevelTwoTextNode" presStyleLbl="node2" presStyleIdx="0" presStyleCnt="2">
        <dgm:presLayoutVars>
          <dgm:chPref val="3"/>
        </dgm:presLayoutVars>
      </dgm:prSet>
      <dgm:spPr/>
      <dgm:t>
        <a:bodyPr/>
        <a:lstStyle/>
        <a:p>
          <a:endParaRPr lang="en-GB"/>
        </a:p>
      </dgm:t>
    </dgm:pt>
    <dgm:pt modelId="{11EAC4EB-61F6-4957-AE2E-428C2540DFA3}" type="pres">
      <dgm:prSet presAssocID="{421D37E8-DF8B-40A2-A3A9-5880088563E1}" presName="level3hierChild" presStyleCnt="0"/>
      <dgm:spPr/>
    </dgm:pt>
    <dgm:pt modelId="{06753AC3-0792-4C20-92F6-2F434D57B36B}" type="pres">
      <dgm:prSet presAssocID="{CBE5E49E-BB02-47F1-9894-1EECB620F7A1}" presName="conn2-1" presStyleLbl="parChTrans1D2" presStyleIdx="1" presStyleCnt="2"/>
      <dgm:spPr/>
      <dgm:t>
        <a:bodyPr/>
        <a:lstStyle/>
        <a:p>
          <a:endParaRPr lang="en-GB"/>
        </a:p>
      </dgm:t>
    </dgm:pt>
    <dgm:pt modelId="{1E345089-21A0-4E0D-92B2-C3865027B151}" type="pres">
      <dgm:prSet presAssocID="{CBE5E49E-BB02-47F1-9894-1EECB620F7A1}" presName="connTx" presStyleLbl="parChTrans1D2" presStyleIdx="1" presStyleCnt="2"/>
      <dgm:spPr/>
      <dgm:t>
        <a:bodyPr/>
        <a:lstStyle/>
        <a:p>
          <a:endParaRPr lang="en-GB"/>
        </a:p>
      </dgm:t>
    </dgm:pt>
    <dgm:pt modelId="{B881C976-0ACF-4FA4-AF6B-208E4A7D4BAE}" type="pres">
      <dgm:prSet presAssocID="{876020D4-47BB-49EB-A02C-EC2DE430D0F2}" presName="root2" presStyleCnt="0"/>
      <dgm:spPr/>
    </dgm:pt>
    <dgm:pt modelId="{416E667C-1440-4079-AD1A-A3003EE5D3BA}" type="pres">
      <dgm:prSet presAssocID="{876020D4-47BB-49EB-A02C-EC2DE430D0F2}" presName="LevelTwoTextNode" presStyleLbl="node2" presStyleIdx="1" presStyleCnt="2">
        <dgm:presLayoutVars>
          <dgm:chPref val="3"/>
        </dgm:presLayoutVars>
      </dgm:prSet>
      <dgm:spPr/>
      <dgm:t>
        <a:bodyPr/>
        <a:lstStyle/>
        <a:p>
          <a:endParaRPr lang="en-GB"/>
        </a:p>
      </dgm:t>
    </dgm:pt>
    <dgm:pt modelId="{628CDD42-4916-4179-9E21-B1AADCFF4749}" type="pres">
      <dgm:prSet presAssocID="{876020D4-47BB-49EB-A02C-EC2DE430D0F2}" presName="level3hierChild" presStyleCnt="0"/>
      <dgm:spPr/>
    </dgm:pt>
  </dgm:ptLst>
  <dgm:cxnLst>
    <dgm:cxn modelId="{1958B9E9-23DD-433B-9EBA-2D5622EF713E}" type="presOf" srcId="{876020D4-47BB-49EB-A02C-EC2DE430D0F2}" destId="{416E667C-1440-4079-AD1A-A3003EE5D3BA}" srcOrd="0" destOrd="0" presId="urn:microsoft.com/office/officeart/2005/8/layout/hierarchy2"/>
    <dgm:cxn modelId="{58EE711C-DFF4-46DE-813E-3D78DE0168BE}" type="presOf" srcId="{FE09D7EF-4568-4064-861F-D65552ACA096}" destId="{F3A97E10-34EE-4BBB-B629-42D0E6AD301C}" srcOrd="0" destOrd="0" presId="urn:microsoft.com/office/officeart/2005/8/layout/hierarchy2"/>
    <dgm:cxn modelId="{EC525CED-F53D-472C-9561-1E7A20681C01}" srcId="{D9BC3921-C5C6-46C2-928A-8519CF085E50}" destId="{421D37E8-DF8B-40A2-A3A9-5880088563E1}" srcOrd="0" destOrd="0" parTransId="{FE09D7EF-4568-4064-861F-D65552ACA096}" sibTransId="{A1CFE19D-B289-4F8A-8338-2F3DA5841785}"/>
    <dgm:cxn modelId="{F5C62860-4225-44B7-A3FE-CCB76032FBE1}" srcId="{197444FA-EBAB-4344-BCAA-AD1EDCF18D56}" destId="{D9BC3921-C5C6-46C2-928A-8519CF085E50}" srcOrd="0" destOrd="0" parTransId="{B6F44240-2E25-449E-BFC5-AD11AABC8461}" sibTransId="{91CD3A84-80D6-4A0A-B036-E923D3C2D679}"/>
    <dgm:cxn modelId="{73A08A2B-421F-444F-B340-352A77B2307B}" type="presOf" srcId="{FE09D7EF-4568-4064-861F-D65552ACA096}" destId="{406F40F1-90D9-48A9-B27E-72FB00422106}" srcOrd="1" destOrd="0" presId="urn:microsoft.com/office/officeart/2005/8/layout/hierarchy2"/>
    <dgm:cxn modelId="{3CBC2440-A4C7-4ACE-AB0D-B64E12234A6F}" type="presOf" srcId="{197444FA-EBAB-4344-BCAA-AD1EDCF18D56}" destId="{29FCF24C-2DE6-4D86-98D9-87524F46A1E2}" srcOrd="0" destOrd="0" presId="urn:microsoft.com/office/officeart/2005/8/layout/hierarchy2"/>
    <dgm:cxn modelId="{D9EA3845-25A5-4D15-B3D9-FE10DD57D0F1}" type="presOf" srcId="{CBE5E49E-BB02-47F1-9894-1EECB620F7A1}" destId="{06753AC3-0792-4C20-92F6-2F434D57B36B}" srcOrd="0" destOrd="0" presId="urn:microsoft.com/office/officeart/2005/8/layout/hierarchy2"/>
    <dgm:cxn modelId="{09C3C676-E85F-4384-98DA-EAFD39523E07}" srcId="{D9BC3921-C5C6-46C2-928A-8519CF085E50}" destId="{876020D4-47BB-49EB-A02C-EC2DE430D0F2}" srcOrd="1" destOrd="0" parTransId="{CBE5E49E-BB02-47F1-9894-1EECB620F7A1}" sibTransId="{344C9FCE-46B7-4224-8C78-90759D5A61B0}"/>
    <dgm:cxn modelId="{B47FE6F9-F6AF-4546-BE30-EE841F810393}" type="presOf" srcId="{CBE5E49E-BB02-47F1-9894-1EECB620F7A1}" destId="{1E345089-21A0-4E0D-92B2-C3865027B151}" srcOrd="1" destOrd="0" presId="urn:microsoft.com/office/officeart/2005/8/layout/hierarchy2"/>
    <dgm:cxn modelId="{E9A52DFC-2E39-458E-BD35-0068FF20B2CD}" type="presOf" srcId="{421D37E8-DF8B-40A2-A3A9-5880088563E1}" destId="{3F75941D-CC1C-4EA3-8A1F-EB8F3E8800EA}" srcOrd="0" destOrd="0" presId="urn:microsoft.com/office/officeart/2005/8/layout/hierarchy2"/>
    <dgm:cxn modelId="{9E9839DB-93E0-4FEC-8724-00F8498F59F3}" type="presOf" srcId="{D9BC3921-C5C6-46C2-928A-8519CF085E50}" destId="{A7811A13-B682-4B70-A412-512B711BF07F}" srcOrd="0" destOrd="0" presId="urn:microsoft.com/office/officeart/2005/8/layout/hierarchy2"/>
    <dgm:cxn modelId="{33096FBD-77D5-4256-885E-E6E6EC748C2C}" type="presParOf" srcId="{29FCF24C-2DE6-4D86-98D9-87524F46A1E2}" destId="{2BD1E0AA-6F23-4818-9DAF-6F48FE6AB948}" srcOrd="0" destOrd="0" presId="urn:microsoft.com/office/officeart/2005/8/layout/hierarchy2"/>
    <dgm:cxn modelId="{0713D6C3-E7B6-4873-8E89-24D519EF58B5}" type="presParOf" srcId="{2BD1E0AA-6F23-4818-9DAF-6F48FE6AB948}" destId="{A7811A13-B682-4B70-A412-512B711BF07F}" srcOrd="0" destOrd="0" presId="urn:microsoft.com/office/officeart/2005/8/layout/hierarchy2"/>
    <dgm:cxn modelId="{C0880B1C-FF98-4883-9FBB-EB450F30744F}" type="presParOf" srcId="{2BD1E0AA-6F23-4818-9DAF-6F48FE6AB948}" destId="{B129C3B7-4FD9-417B-B8A2-96AC41D41E4D}" srcOrd="1" destOrd="0" presId="urn:microsoft.com/office/officeart/2005/8/layout/hierarchy2"/>
    <dgm:cxn modelId="{60640F03-1D2A-4AE0-B8A2-286959521C71}" type="presParOf" srcId="{B129C3B7-4FD9-417B-B8A2-96AC41D41E4D}" destId="{F3A97E10-34EE-4BBB-B629-42D0E6AD301C}" srcOrd="0" destOrd="0" presId="urn:microsoft.com/office/officeart/2005/8/layout/hierarchy2"/>
    <dgm:cxn modelId="{B4A01DB0-EADD-4990-A693-9B86E886BA85}" type="presParOf" srcId="{F3A97E10-34EE-4BBB-B629-42D0E6AD301C}" destId="{406F40F1-90D9-48A9-B27E-72FB00422106}" srcOrd="0" destOrd="0" presId="urn:microsoft.com/office/officeart/2005/8/layout/hierarchy2"/>
    <dgm:cxn modelId="{EEEECBFC-9D09-4097-9D5D-E1A08781DA76}" type="presParOf" srcId="{B129C3B7-4FD9-417B-B8A2-96AC41D41E4D}" destId="{8A0858B8-7766-492F-A40E-068658E8D063}" srcOrd="1" destOrd="0" presId="urn:microsoft.com/office/officeart/2005/8/layout/hierarchy2"/>
    <dgm:cxn modelId="{AC0478CF-349E-4491-B103-C67333413FEF}" type="presParOf" srcId="{8A0858B8-7766-492F-A40E-068658E8D063}" destId="{3F75941D-CC1C-4EA3-8A1F-EB8F3E8800EA}" srcOrd="0" destOrd="0" presId="urn:microsoft.com/office/officeart/2005/8/layout/hierarchy2"/>
    <dgm:cxn modelId="{D5A7FBFF-13FB-4B7B-9486-6E3DA93C7130}" type="presParOf" srcId="{8A0858B8-7766-492F-A40E-068658E8D063}" destId="{11EAC4EB-61F6-4957-AE2E-428C2540DFA3}" srcOrd="1" destOrd="0" presId="urn:microsoft.com/office/officeart/2005/8/layout/hierarchy2"/>
    <dgm:cxn modelId="{FF68A3D1-BE54-4A6A-995D-EA0FEF53FAD6}" type="presParOf" srcId="{B129C3B7-4FD9-417B-B8A2-96AC41D41E4D}" destId="{06753AC3-0792-4C20-92F6-2F434D57B36B}" srcOrd="2" destOrd="0" presId="urn:microsoft.com/office/officeart/2005/8/layout/hierarchy2"/>
    <dgm:cxn modelId="{B39D4105-A82A-4302-8C82-19E85FE2BB3D}" type="presParOf" srcId="{06753AC3-0792-4C20-92F6-2F434D57B36B}" destId="{1E345089-21A0-4E0D-92B2-C3865027B151}" srcOrd="0" destOrd="0" presId="urn:microsoft.com/office/officeart/2005/8/layout/hierarchy2"/>
    <dgm:cxn modelId="{0B5C0AA6-A141-48D4-BC79-DC24AB2A3821}" type="presParOf" srcId="{B129C3B7-4FD9-417B-B8A2-96AC41D41E4D}" destId="{B881C976-0ACF-4FA4-AF6B-208E4A7D4BAE}" srcOrd="3" destOrd="0" presId="urn:microsoft.com/office/officeart/2005/8/layout/hierarchy2"/>
    <dgm:cxn modelId="{5466D7A5-AED5-4F64-930B-FF268065C8BA}" type="presParOf" srcId="{B881C976-0ACF-4FA4-AF6B-208E4A7D4BAE}" destId="{416E667C-1440-4079-AD1A-A3003EE5D3BA}" srcOrd="0" destOrd="0" presId="urn:microsoft.com/office/officeart/2005/8/layout/hierarchy2"/>
    <dgm:cxn modelId="{AE5A8E0F-0759-43F3-A363-D67935189CB0}" type="presParOf" srcId="{B881C976-0ACF-4FA4-AF6B-208E4A7D4BAE}" destId="{628CDD42-4916-4179-9E21-B1AADCFF4749}" srcOrd="1" destOrd="0" presId="urn:microsoft.com/office/officeart/2005/8/layout/hierarchy2"/>
  </dgm:cxnLst>
  <dgm:bg/>
  <dgm:whole/>
</dgm:dataModel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D386F9-55AA-F940-8E7C-DD5982DF2DBD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52463" y="1143000"/>
            <a:ext cx="55530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6587CD-7DAD-E24D-8B8A-638B6CA1831A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86412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10419" y="589500"/>
            <a:ext cx="4862513" cy="1254043"/>
          </a:xfrm>
        </p:spPr>
        <p:txBody>
          <a:bodyPr anchor="b"/>
          <a:lstStyle>
            <a:lvl1pPr algn="ctr">
              <a:defRPr sz="315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419" y="1891904"/>
            <a:ext cx="4862513" cy="869658"/>
          </a:xfrm>
        </p:spPr>
        <p:txBody>
          <a:bodyPr/>
          <a:lstStyle>
            <a:lvl1pPr marL="0" indent="0" algn="ctr">
              <a:buNone/>
              <a:defRPr sz="1260"/>
            </a:lvl1pPr>
            <a:lvl2pPr marL="240121" indent="0" algn="ctr">
              <a:buNone/>
              <a:defRPr sz="1050"/>
            </a:lvl2pPr>
            <a:lvl3pPr marL="480243" indent="0" algn="ctr">
              <a:buNone/>
              <a:defRPr sz="945"/>
            </a:lvl3pPr>
            <a:lvl4pPr marL="720364" indent="0" algn="ctr">
              <a:buNone/>
              <a:defRPr sz="840"/>
            </a:lvl4pPr>
            <a:lvl5pPr marL="960486" indent="0" algn="ctr">
              <a:buNone/>
              <a:defRPr sz="840"/>
            </a:lvl5pPr>
            <a:lvl6pPr marL="1200607" indent="0" algn="ctr">
              <a:buNone/>
              <a:defRPr sz="840"/>
            </a:lvl6pPr>
            <a:lvl7pPr marL="1440729" indent="0" algn="ctr">
              <a:buNone/>
              <a:defRPr sz="840"/>
            </a:lvl7pPr>
            <a:lvl8pPr marL="1680850" indent="0" algn="ctr">
              <a:buNone/>
              <a:defRPr sz="840"/>
            </a:lvl8pPr>
            <a:lvl9pPr marL="1920972" indent="0" algn="ctr">
              <a:buNone/>
              <a:defRPr sz="8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61842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26046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9648" y="191775"/>
            <a:ext cx="1397972" cy="305256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730" y="191775"/>
            <a:ext cx="4112875" cy="305256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1325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19265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354" y="898009"/>
            <a:ext cx="5591889" cy="1498347"/>
          </a:xfrm>
        </p:spPr>
        <p:txBody>
          <a:bodyPr anchor="b"/>
          <a:lstStyle>
            <a:lvl1pPr>
              <a:defRPr sz="315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354" y="2410531"/>
            <a:ext cx="5591889" cy="787946"/>
          </a:xfrm>
        </p:spPr>
        <p:txBody>
          <a:bodyPr/>
          <a:lstStyle>
            <a:lvl1pPr marL="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1pPr>
            <a:lvl2pPr marL="240121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2pPr>
            <a:lvl3pPr marL="480243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3pPr>
            <a:lvl4pPr marL="720364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4pPr>
            <a:lvl5pPr marL="960486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5pPr>
            <a:lvl6pPr marL="1200607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6pPr>
            <a:lvl7pPr marL="1440729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7pPr>
            <a:lvl8pPr marL="1680850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8pPr>
            <a:lvl9pPr marL="1920972" indent="0">
              <a:buNone/>
              <a:defRPr sz="8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62743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730" y="958876"/>
            <a:ext cx="2755424" cy="22854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2196" y="958876"/>
            <a:ext cx="2755424" cy="228546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91947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575" y="191775"/>
            <a:ext cx="5591889" cy="69622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575" y="883000"/>
            <a:ext cx="2742761" cy="432745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121" indent="0">
              <a:buNone/>
              <a:defRPr sz="1050" b="1"/>
            </a:lvl2pPr>
            <a:lvl3pPr marL="480243" indent="0">
              <a:buNone/>
              <a:defRPr sz="945" b="1"/>
            </a:lvl3pPr>
            <a:lvl4pPr marL="720364" indent="0">
              <a:buNone/>
              <a:defRPr sz="840" b="1"/>
            </a:lvl4pPr>
            <a:lvl5pPr marL="960486" indent="0">
              <a:buNone/>
              <a:defRPr sz="840" b="1"/>
            </a:lvl5pPr>
            <a:lvl6pPr marL="1200607" indent="0">
              <a:buNone/>
              <a:defRPr sz="840" b="1"/>
            </a:lvl6pPr>
            <a:lvl7pPr marL="1440729" indent="0">
              <a:buNone/>
              <a:defRPr sz="840" b="1"/>
            </a:lvl7pPr>
            <a:lvl8pPr marL="1680850" indent="0">
              <a:buNone/>
              <a:defRPr sz="840" b="1"/>
            </a:lvl8pPr>
            <a:lvl9pPr marL="1920972" indent="0">
              <a:buNone/>
              <a:defRPr sz="8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575" y="1315744"/>
            <a:ext cx="2742761" cy="19352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2196" y="883000"/>
            <a:ext cx="2756268" cy="432745"/>
          </a:xfrm>
        </p:spPr>
        <p:txBody>
          <a:bodyPr anchor="b"/>
          <a:lstStyle>
            <a:lvl1pPr marL="0" indent="0">
              <a:buNone/>
              <a:defRPr sz="1260" b="1"/>
            </a:lvl1pPr>
            <a:lvl2pPr marL="240121" indent="0">
              <a:buNone/>
              <a:defRPr sz="1050" b="1"/>
            </a:lvl2pPr>
            <a:lvl3pPr marL="480243" indent="0">
              <a:buNone/>
              <a:defRPr sz="945" b="1"/>
            </a:lvl3pPr>
            <a:lvl4pPr marL="720364" indent="0">
              <a:buNone/>
              <a:defRPr sz="840" b="1"/>
            </a:lvl4pPr>
            <a:lvl5pPr marL="960486" indent="0">
              <a:buNone/>
              <a:defRPr sz="840" b="1"/>
            </a:lvl5pPr>
            <a:lvl6pPr marL="1200607" indent="0">
              <a:buNone/>
              <a:defRPr sz="840" b="1"/>
            </a:lvl6pPr>
            <a:lvl7pPr marL="1440729" indent="0">
              <a:buNone/>
              <a:defRPr sz="840" b="1"/>
            </a:lvl7pPr>
            <a:lvl8pPr marL="1680850" indent="0">
              <a:buNone/>
              <a:defRPr sz="840" b="1"/>
            </a:lvl8pPr>
            <a:lvl9pPr marL="1920972" indent="0">
              <a:buNone/>
              <a:defRPr sz="8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2196" y="1315744"/>
            <a:ext cx="2756268" cy="19352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924731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909616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49992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575" y="240136"/>
            <a:ext cx="2091049" cy="840476"/>
          </a:xfrm>
        </p:spPr>
        <p:txBody>
          <a:bodyPr anchor="b"/>
          <a:lstStyle>
            <a:lvl1pPr>
              <a:defRPr sz="16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6268" y="518627"/>
            <a:ext cx="3282196" cy="2559782"/>
          </a:xfrm>
        </p:spPr>
        <p:txBody>
          <a:bodyPr/>
          <a:lstStyle>
            <a:lvl1pPr>
              <a:defRPr sz="1681"/>
            </a:lvl1pPr>
            <a:lvl2pPr>
              <a:defRPr sz="1471"/>
            </a:lvl2pPr>
            <a:lvl3pPr>
              <a:defRPr sz="1260"/>
            </a:lvl3pPr>
            <a:lvl4pPr>
              <a:defRPr sz="1050"/>
            </a:lvl4pPr>
            <a:lvl5pPr>
              <a:defRPr sz="1050"/>
            </a:lvl5pPr>
            <a:lvl6pPr>
              <a:defRPr sz="1050"/>
            </a:lvl6pPr>
            <a:lvl7pPr>
              <a:defRPr sz="1050"/>
            </a:lvl7pPr>
            <a:lvl8pPr>
              <a:defRPr sz="1050"/>
            </a:lvl8pPr>
            <a:lvl9pPr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575" y="1080612"/>
            <a:ext cx="2091049" cy="2001966"/>
          </a:xfrm>
        </p:spPr>
        <p:txBody>
          <a:bodyPr/>
          <a:lstStyle>
            <a:lvl1pPr marL="0" indent="0">
              <a:buNone/>
              <a:defRPr sz="840"/>
            </a:lvl1pPr>
            <a:lvl2pPr marL="240121" indent="0">
              <a:buNone/>
              <a:defRPr sz="735"/>
            </a:lvl2pPr>
            <a:lvl3pPr marL="480243" indent="0">
              <a:buNone/>
              <a:defRPr sz="630"/>
            </a:lvl3pPr>
            <a:lvl4pPr marL="720364" indent="0">
              <a:buNone/>
              <a:defRPr sz="525"/>
            </a:lvl4pPr>
            <a:lvl5pPr marL="960486" indent="0">
              <a:buNone/>
              <a:defRPr sz="525"/>
            </a:lvl5pPr>
            <a:lvl6pPr marL="1200607" indent="0">
              <a:buNone/>
              <a:defRPr sz="525"/>
            </a:lvl6pPr>
            <a:lvl7pPr marL="1440729" indent="0">
              <a:buNone/>
              <a:defRPr sz="525"/>
            </a:lvl7pPr>
            <a:lvl8pPr marL="1680850" indent="0">
              <a:buNone/>
              <a:defRPr sz="525"/>
            </a:lvl8pPr>
            <a:lvl9pPr marL="1920972" indent="0">
              <a:buNone/>
              <a:defRPr sz="5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677824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575" y="240136"/>
            <a:ext cx="2091049" cy="840476"/>
          </a:xfrm>
        </p:spPr>
        <p:txBody>
          <a:bodyPr anchor="b"/>
          <a:lstStyle>
            <a:lvl1pPr>
              <a:defRPr sz="16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6268" y="518627"/>
            <a:ext cx="3282196" cy="2559782"/>
          </a:xfrm>
        </p:spPr>
        <p:txBody>
          <a:bodyPr anchor="t"/>
          <a:lstStyle>
            <a:lvl1pPr marL="0" indent="0">
              <a:buNone/>
              <a:defRPr sz="1681"/>
            </a:lvl1pPr>
            <a:lvl2pPr marL="240121" indent="0">
              <a:buNone/>
              <a:defRPr sz="1471"/>
            </a:lvl2pPr>
            <a:lvl3pPr marL="480243" indent="0">
              <a:buNone/>
              <a:defRPr sz="1260"/>
            </a:lvl3pPr>
            <a:lvl4pPr marL="720364" indent="0">
              <a:buNone/>
              <a:defRPr sz="1050"/>
            </a:lvl4pPr>
            <a:lvl5pPr marL="960486" indent="0">
              <a:buNone/>
              <a:defRPr sz="1050"/>
            </a:lvl5pPr>
            <a:lvl6pPr marL="1200607" indent="0">
              <a:buNone/>
              <a:defRPr sz="1050"/>
            </a:lvl6pPr>
            <a:lvl7pPr marL="1440729" indent="0">
              <a:buNone/>
              <a:defRPr sz="1050"/>
            </a:lvl7pPr>
            <a:lvl8pPr marL="1680850" indent="0">
              <a:buNone/>
              <a:defRPr sz="1050"/>
            </a:lvl8pPr>
            <a:lvl9pPr marL="1920972" indent="0">
              <a:buNone/>
              <a:defRPr sz="10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575" y="1080612"/>
            <a:ext cx="2091049" cy="2001966"/>
          </a:xfrm>
        </p:spPr>
        <p:txBody>
          <a:bodyPr/>
          <a:lstStyle>
            <a:lvl1pPr marL="0" indent="0">
              <a:buNone/>
              <a:defRPr sz="840"/>
            </a:lvl1pPr>
            <a:lvl2pPr marL="240121" indent="0">
              <a:buNone/>
              <a:defRPr sz="735"/>
            </a:lvl2pPr>
            <a:lvl3pPr marL="480243" indent="0">
              <a:buNone/>
              <a:defRPr sz="630"/>
            </a:lvl3pPr>
            <a:lvl4pPr marL="720364" indent="0">
              <a:buNone/>
              <a:defRPr sz="525"/>
            </a:lvl4pPr>
            <a:lvl5pPr marL="960486" indent="0">
              <a:buNone/>
              <a:defRPr sz="525"/>
            </a:lvl5pPr>
            <a:lvl6pPr marL="1200607" indent="0">
              <a:buNone/>
              <a:defRPr sz="525"/>
            </a:lvl6pPr>
            <a:lvl7pPr marL="1440729" indent="0">
              <a:buNone/>
              <a:defRPr sz="525"/>
            </a:lvl7pPr>
            <a:lvl8pPr marL="1680850" indent="0">
              <a:buNone/>
              <a:defRPr sz="525"/>
            </a:lvl8pPr>
            <a:lvl9pPr marL="1920972" indent="0">
              <a:buNone/>
              <a:defRPr sz="5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01366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731" y="191775"/>
            <a:ext cx="5591889" cy="69622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731" y="958876"/>
            <a:ext cx="5591889" cy="22854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730" y="3338556"/>
            <a:ext cx="1458754" cy="191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97D4FD-7530-CC45-A783-A1FFC3FF34F6}" type="datetimeFigureOut">
              <a:rPr lang="en-US" smtClean="0"/>
              <a:pPr/>
              <a:t>7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7610" y="3338556"/>
            <a:ext cx="2188131" cy="191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8866" y="3338556"/>
            <a:ext cx="1458754" cy="191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3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C40E17-1795-CB46-9F3B-8E59E2EB5DF3}" type="slidenum">
              <a:rPr lang="en-US" smtClean="0"/>
              <a:pPr/>
              <a:t>‹Nº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52553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480243" rtl="0" eaLnBrk="1" latinLnBrk="0" hangingPunct="1">
        <a:lnSpc>
          <a:spcPct val="90000"/>
        </a:lnSpc>
        <a:spcBef>
          <a:spcPct val="0"/>
        </a:spcBef>
        <a:buNone/>
        <a:defRPr sz="23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0061" indent="-120061" algn="l" defTabSz="480243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471" kern="1200">
          <a:solidFill>
            <a:schemeClr val="tx1"/>
          </a:solidFill>
          <a:latin typeface="+mn-lt"/>
          <a:ea typeface="+mn-ea"/>
          <a:cs typeface="+mn-cs"/>
        </a:defRPr>
      </a:lvl1pPr>
      <a:lvl2pPr marL="360182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2pPr>
      <a:lvl3pPr marL="600304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1050" kern="1200">
          <a:solidFill>
            <a:schemeClr val="tx1"/>
          </a:solidFill>
          <a:latin typeface="+mn-lt"/>
          <a:ea typeface="+mn-ea"/>
          <a:cs typeface="+mn-cs"/>
        </a:defRPr>
      </a:lvl3pPr>
      <a:lvl4pPr marL="840425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1080546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320668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560789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800911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2041032" indent="-120061" algn="l" defTabSz="480243" rtl="0" eaLnBrk="1" latinLnBrk="0" hangingPunct="1">
        <a:lnSpc>
          <a:spcPct val="90000"/>
        </a:lnSpc>
        <a:spcBef>
          <a:spcPts val="263"/>
        </a:spcBef>
        <a:buFont typeface="Arial" panose="020B0604020202020204" pitchFamily="34" charset="0"/>
        <a:buChar char="•"/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1pPr>
      <a:lvl2pPr marL="240121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2pPr>
      <a:lvl3pPr marL="480243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3pPr>
      <a:lvl4pPr marL="720364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4pPr>
      <a:lvl5pPr marL="960486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5pPr>
      <a:lvl6pPr marL="1200607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6pPr>
      <a:lvl7pPr marL="1440729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7pPr>
      <a:lvl8pPr marL="1680850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8pPr>
      <a:lvl9pPr marL="1920972" algn="l" defTabSz="480243" rtl="0" eaLnBrk="1" latinLnBrk="0" hangingPunct="1">
        <a:defRPr sz="9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18" Type="http://schemas.openxmlformats.org/officeDocument/2006/relationships/diagramLayout" Target="../diagrams/layout1.xml"/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diagramData" Target="../diagrams/data1.xml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diagramColors" Target="../diagrams/colors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png"/><Relationship Id="rId10" Type="http://schemas.openxmlformats.org/officeDocument/2006/relationships/image" Target="../media/image9.jpeg"/><Relationship Id="rId19" Type="http://schemas.openxmlformats.org/officeDocument/2006/relationships/diagramQuickStyle" Target="../diagrams/quickStyle1.xml"/><Relationship Id="rId4" Type="http://schemas.openxmlformats.org/officeDocument/2006/relationships/image" Target="../media/image3.tiff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hevron 5">
            <a:extLst>
              <a:ext uri="{FF2B5EF4-FFF2-40B4-BE49-F238E27FC236}">
                <a16:creationId xmlns="" xmlns:a16="http://schemas.microsoft.com/office/drawing/2014/main" id="{235FA008-1266-E04C-0E13-04682CA3E6D7}"/>
              </a:ext>
            </a:extLst>
          </p:cNvPr>
          <p:cNvSpPr/>
          <p:nvPr/>
        </p:nvSpPr>
        <p:spPr>
          <a:xfrm>
            <a:off x="84407" y="37068"/>
            <a:ext cx="2129676" cy="396000"/>
          </a:xfrm>
          <a:prstGeom prst="chevron">
            <a:avLst>
              <a:gd name="adj" fmla="val 32500"/>
            </a:avLst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smtClean="0">
                <a:solidFill>
                  <a:schemeClr val="bg1"/>
                </a:solidFill>
                <a:latin typeface="Helvetica"/>
                <a:cs typeface="Arial" panose="020B0604020202020204" pitchFamily="34" charset="0"/>
              </a:rPr>
              <a:t>Background</a:t>
            </a:r>
            <a:endParaRPr lang="en-US" sz="900" b="1" dirty="0">
              <a:solidFill>
                <a:schemeClr val="bg1"/>
              </a:solidFill>
              <a:latin typeface="Helvetica"/>
              <a:cs typeface="Arial" panose="020B0604020202020204" pitchFamily="34" charset="0"/>
            </a:endParaRPr>
          </a:p>
        </p:txBody>
      </p:sp>
      <p:sp>
        <p:nvSpPr>
          <p:cNvPr id="7" name="Chevron 6">
            <a:extLst>
              <a:ext uri="{FF2B5EF4-FFF2-40B4-BE49-F238E27FC236}">
                <a16:creationId xmlns="" xmlns:a16="http://schemas.microsoft.com/office/drawing/2014/main" id="{4EE9B46F-CA30-3976-DCDA-4572D4D978B9}"/>
              </a:ext>
            </a:extLst>
          </p:cNvPr>
          <p:cNvSpPr/>
          <p:nvPr/>
        </p:nvSpPr>
        <p:spPr>
          <a:xfrm>
            <a:off x="2176838" y="37068"/>
            <a:ext cx="2129676" cy="396000"/>
          </a:xfrm>
          <a:prstGeom prst="chevron">
            <a:avLst>
              <a:gd name="adj" fmla="val 32500"/>
            </a:avLst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smtClean="0">
                <a:solidFill>
                  <a:schemeClr val="bg1"/>
                </a:solidFill>
                <a:latin typeface="Helvetica"/>
                <a:cs typeface="Arial" panose="020B0604020202020204" pitchFamily="34" charset="0"/>
              </a:rPr>
              <a:t>Methods</a:t>
            </a:r>
            <a:endParaRPr lang="en-US" sz="900" b="1" dirty="0">
              <a:solidFill>
                <a:schemeClr val="bg1"/>
              </a:solidFill>
              <a:latin typeface="Helvetica"/>
              <a:cs typeface="Arial" panose="020B0604020202020204" pitchFamily="34" charset="0"/>
            </a:endParaRPr>
          </a:p>
        </p:txBody>
      </p:sp>
      <p:sp>
        <p:nvSpPr>
          <p:cNvPr id="8" name="Chevron 7">
            <a:extLst>
              <a:ext uri="{FF2B5EF4-FFF2-40B4-BE49-F238E27FC236}">
                <a16:creationId xmlns="" xmlns:a16="http://schemas.microsoft.com/office/drawing/2014/main" id="{64B1E8A5-853B-0748-074F-E8E61EFAA46F}"/>
              </a:ext>
            </a:extLst>
          </p:cNvPr>
          <p:cNvSpPr/>
          <p:nvPr/>
        </p:nvSpPr>
        <p:spPr>
          <a:xfrm>
            <a:off x="4269268" y="37068"/>
            <a:ext cx="2129676" cy="396000"/>
          </a:xfrm>
          <a:prstGeom prst="chevron">
            <a:avLst>
              <a:gd name="adj" fmla="val 32500"/>
            </a:avLst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b="1" smtClean="0">
                <a:solidFill>
                  <a:schemeClr val="bg1"/>
                </a:solidFill>
                <a:latin typeface="Helvetica"/>
                <a:cs typeface="Arial" panose="020B0604020202020204" pitchFamily="34" charset="0"/>
              </a:rPr>
              <a:t>Results</a:t>
            </a:r>
            <a:endParaRPr lang="en-US" sz="900" b="1" dirty="0">
              <a:solidFill>
                <a:schemeClr val="bg1"/>
              </a:solidFill>
              <a:latin typeface="Helvetica"/>
              <a:cs typeface="Arial" panose="020B0604020202020204" pitchFamily="34" charset="0"/>
            </a:endParaRPr>
          </a:p>
        </p:txBody>
      </p:sp>
      <p:pic>
        <p:nvPicPr>
          <p:cNvPr id="11" name="3 Marcador de contenido" descr="patient-icon-19.jpg">
            <a:extLst>
              <a:ext uri="{FF2B5EF4-FFF2-40B4-BE49-F238E27FC236}">
                <a16:creationId xmlns="" xmlns:a16="http://schemas.microsoft.com/office/drawing/2014/main" id="{6F1C41DC-99B8-A600-1D77-EA297ABA0B7E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06495" y="486123"/>
            <a:ext cx="353502" cy="316908"/>
          </a:xfrm>
          <a:prstGeom prst="rect">
            <a:avLst/>
          </a:prstGeom>
        </p:spPr>
      </p:pic>
      <p:pic>
        <p:nvPicPr>
          <p:cNvPr id="14" name="Picture 3" descr="F:\ECCMID 2021\Presentaciones ECCMID 2021\bathroom.png">
            <a:extLst>
              <a:ext uri="{FF2B5EF4-FFF2-40B4-BE49-F238E27FC236}">
                <a16:creationId xmlns="" xmlns:a16="http://schemas.microsoft.com/office/drawing/2014/main" id="{27C573E9-C168-D987-B301-31119A129AD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 rot="10800000" flipH="1" flipV="1">
            <a:off x="1323997" y="581836"/>
            <a:ext cx="185000" cy="185000"/>
          </a:xfrm>
          <a:prstGeom prst="rect">
            <a:avLst/>
          </a:prstGeom>
          <a:noFill/>
        </p:spPr>
      </p:pic>
      <p:pic>
        <p:nvPicPr>
          <p:cNvPr id="15" name="14 Imagen" descr="Figure1_Calprotectin_ROC.tif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41631" y="510833"/>
            <a:ext cx="1414931" cy="707466"/>
          </a:xfrm>
          <a:prstGeom prst="rect">
            <a:avLst/>
          </a:prstGeom>
        </p:spPr>
      </p:pic>
      <p:pic>
        <p:nvPicPr>
          <p:cNvPr id="17" name="16 Imagen" descr="Figure3_Abund_deseq_first_CDI_RECURRENCIA.tif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41631" y="1273241"/>
            <a:ext cx="1549004" cy="774502"/>
          </a:xfrm>
          <a:prstGeom prst="rect">
            <a:avLst/>
          </a:prstGeom>
        </p:spPr>
      </p:pic>
      <p:pic>
        <p:nvPicPr>
          <p:cNvPr id="18" name="17 Imagen" descr="Figure4_Abund_deseq_first_CDI_grup185_calpro.tif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41631" y="2107559"/>
            <a:ext cx="1611865" cy="805933"/>
          </a:xfrm>
          <a:prstGeom prst="rect">
            <a:avLst/>
          </a:prstGeom>
        </p:spPr>
      </p:pic>
      <p:grpSp>
        <p:nvGrpSpPr>
          <p:cNvPr id="19" name="Grupo 1">
            <a:extLst>
              <a:ext uri="{FF2B5EF4-FFF2-40B4-BE49-F238E27FC236}">
                <a16:creationId xmlns="" xmlns:a16="http://schemas.microsoft.com/office/drawing/2014/main" id="{FD8146C3-A0B4-AF4D-BE93-8CF267FACA82}"/>
              </a:ext>
            </a:extLst>
          </p:cNvPr>
          <p:cNvGrpSpPr/>
          <p:nvPr/>
        </p:nvGrpSpPr>
        <p:grpSpPr>
          <a:xfrm>
            <a:off x="2641444" y="612295"/>
            <a:ext cx="1112244" cy="720574"/>
            <a:chOff x="7586902" y="2921000"/>
            <a:chExt cx="3953338" cy="3262550"/>
          </a:xfrm>
        </p:grpSpPr>
        <p:pic>
          <p:nvPicPr>
            <p:cNvPr id="20" name="Picture 4" descr="F:\ECCMID 2021\Presentaciones ECCMID 2021\cdiff-quikchek.jpg">
              <a:extLst>
                <a:ext uri="{FF2B5EF4-FFF2-40B4-BE49-F238E27FC236}">
                  <a16:creationId xmlns="" xmlns:a16="http://schemas.microsoft.com/office/drawing/2014/main" id="{DF2B5BC2-59A4-1249-BA10-718B65383A4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10284870" y="2921000"/>
              <a:ext cx="952428" cy="900000"/>
            </a:xfrm>
            <a:prstGeom prst="rect">
              <a:avLst/>
            </a:prstGeom>
            <a:noFill/>
          </p:spPr>
        </p:pic>
        <p:pic>
          <p:nvPicPr>
            <p:cNvPr id="21" name="Imagen 2">
              <a:extLst>
                <a:ext uri="{FF2B5EF4-FFF2-40B4-BE49-F238E27FC236}">
                  <a16:creationId xmlns="" xmlns:a16="http://schemas.microsoft.com/office/drawing/2014/main" id="{B35D2832-617C-7D4A-B204-6A3EB3801B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="" xmlns:a14="http://schemas.microsoft.com/office/drawing/2010/main">
                    <a14:imgLayer r:embed="">
                      <a14:imgEffect>
                        <a14:brightnessContrast bright="17000"/>
                      </a14:imgEffect>
                    </a14:imgLayer>
                  </a14:imgProps>
                </a:ext>
              </a:extLst>
            </a:blip>
            <a:srcRect l="4369" r="5714"/>
            <a:stretch/>
          </p:blipFill>
          <p:spPr>
            <a:xfrm>
              <a:off x="7586902" y="4923550"/>
              <a:ext cx="2014154" cy="1260000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2" name="Imagen 5">
              <a:extLst>
                <a:ext uri="{FF2B5EF4-FFF2-40B4-BE49-F238E27FC236}">
                  <a16:creationId xmlns="" xmlns:a16="http://schemas.microsoft.com/office/drawing/2014/main" id="{E81680DF-A015-A441-B209-A1F5F441ED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="" xmlns:a14="http://schemas.microsoft.com/office/drawing/2010/main">
                    <a14:imgLayer r:embed="">
                      <a14:imgEffect>
                        <a14:brightnessContrast bright="12000"/>
                      </a14:imgEffect>
                    </a14:imgLayer>
                  </a14:imgProps>
                </a:ext>
              </a:extLst>
            </a:blip>
            <a:srcRect l="13295"/>
            <a:stretch/>
          </p:blipFill>
          <p:spPr>
            <a:xfrm>
              <a:off x="9598048" y="4923550"/>
              <a:ext cx="1942192" cy="1260000"/>
            </a:xfrm>
            <a:prstGeom prst="rect">
              <a:avLst/>
            </a:prstGeom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3" name="Picture 2" descr="F:\ECCMID 2021\Presentaciones ECCMID 2021\2_20210628_135647.jpg">
              <a:extLst>
                <a:ext uri="{FF2B5EF4-FFF2-40B4-BE49-F238E27FC236}">
                  <a16:creationId xmlns="" xmlns:a16="http://schemas.microsoft.com/office/drawing/2014/main" id="{0B8D3D1B-119C-C443-AE3C-ED226A09C7A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 l="23813" r="22609" b="23812"/>
            <a:stretch>
              <a:fillRect/>
            </a:stretch>
          </p:blipFill>
          <p:spPr bwMode="auto">
            <a:xfrm rot="21413877">
              <a:off x="8360701" y="3142806"/>
              <a:ext cx="945150" cy="1008000"/>
            </a:xfrm>
            <a:prstGeom prst="rect">
              <a:avLst/>
            </a:prstGeom>
            <a:noFill/>
            <a:ln>
              <a:solidFill>
                <a:srgbClr val="F9BB32"/>
              </a:solidFill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</p:pic>
        <p:pic>
          <p:nvPicPr>
            <p:cNvPr id="24" name="Picture 2" descr="F:\Jornadas IISGM 2021\PHIL_3211.tif">
              <a:extLst>
                <a:ext uri="{FF2B5EF4-FFF2-40B4-BE49-F238E27FC236}">
                  <a16:creationId xmlns="" xmlns:a16="http://schemas.microsoft.com/office/drawing/2014/main" id="{0F70C21D-E493-744C-AB3D-EF2DF913F79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10303921" y="3892140"/>
              <a:ext cx="985835" cy="648000"/>
            </a:xfrm>
            <a:prstGeom prst="rect">
              <a:avLst/>
            </a:prstGeom>
            <a:ln>
              <a:noFill/>
            </a:ln>
            <a:effectLst>
              <a:outerShdw blurRad="292100" dist="139700" dir="2700000" algn="tl" rotWithShape="0">
                <a:srgbClr val="333333">
                  <a:alpha val="65000"/>
                </a:srgbClr>
              </a:outerShdw>
            </a:effectLst>
          </p:spPr>
        </p:pic>
        <p:sp>
          <p:nvSpPr>
            <p:cNvPr id="25" name="Flecha a la derecha con bandas 14">
              <a:extLst>
                <a:ext uri="{FF2B5EF4-FFF2-40B4-BE49-F238E27FC236}">
                  <a16:creationId xmlns="" xmlns:a16="http://schemas.microsoft.com/office/drawing/2014/main" id="{E364BD44-EDE8-684D-931A-6E6CF63548C9}"/>
                </a:ext>
              </a:extLst>
            </p:cNvPr>
            <p:cNvSpPr/>
            <p:nvPr/>
          </p:nvSpPr>
          <p:spPr>
            <a:xfrm rot="20677456">
              <a:off x="9553081" y="3507956"/>
              <a:ext cx="485752" cy="277700"/>
            </a:xfrm>
            <a:prstGeom prst="stripedRightArrow">
              <a:avLst/>
            </a:prstGeom>
            <a:solidFill>
              <a:srgbClr val="F9BB32"/>
            </a:solidFill>
            <a:ln>
              <a:noFill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0 w 485752"/>
                        <a:gd name="connsiteY0" fmla="*/ 69425 h 277700"/>
                        <a:gd name="connsiteX1" fmla="*/ 8678 w 485752"/>
                        <a:gd name="connsiteY1" fmla="*/ 69425 h 277700"/>
                        <a:gd name="connsiteX2" fmla="*/ 8678 w 485752"/>
                        <a:gd name="connsiteY2" fmla="*/ 208275 h 277700"/>
                        <a:gd name="connsiteX3" fmla="*/ 0 w 485752"/>
                        <a:gd name="connsiteY3" fmla="*/ 208275 h 277700"/>
                        <a:gd name="connsiteX4" fmla="*/ 0 w 485752"/>
                        <a:gd name="connsiteY4" fmla="*/ 69425 h 277700"/>
                        <a:gd name="connsiteX5" fmla="*/ 17356 w 485752"/>
                        <a:gd name="connsiteY5" fmla="*/ 69425 h 277700"/>
                        <a:gd name="connsiteX6" fmla="*/ 34713 w 485752"/>
                        <a:gd name="connsiteY6" fmla="*/ 69425 h 277700"/>
                        <a:gd name="connsiteX7" fmla="*/ 34713 w 485752"/>
                        <a:gd name="connsiteY7" fmla="*/ 208275 h 277700"/>
                        <a:gd name="connsiteX8" fmla="*/ 17356 w 485752"/>
                        <a:gd name="connsiteY8" fmla="*/ 208275 h 277700"/>
                        <a:gd name="connsiteX9" fmla="*/ 17356 w 485752"/>
                        <a:gd name="connsiteY9" fmla="*/ 69425 h 277700"/>
                        <a:gd name="connsiteX10" fmla="*/ 43391 w 485752"/>
                        <a:gd name="connsiteY10" fmla="*/ 69425 h 277700"/>
                        <a:gd name="connsiteX11" fmla="*/ 346902 w 485752"/>
                        <a:gd name="connsiteY11" fmla="*/ 69425 h 277700"/>
                        <a:gd name="connsiteX12" fmla="*/ 346902 w 485752"/>
                        <a:gd name="connsiteY12" fmla="*/ 0 h 277700"/>
                        <a:gd name="connsiteX13" fmla="*/ 485752 w 485752"/>
                        <a:gd name="connsiteY13" fmla="*/ 138850 h 277700"/>
                        <a:gd name="connsiteX14" fmla="*/ 346902 w 485752"/>
                        <a:gd name="connsiteY14" fmla="*/ 277700 h 277700"/>
                        <a:gd name="connsiteX15" fmla="*/ 346902 w 485752"/>
                        <a:gd name="connsiteY15" fmla="*/ 208275 h 277700"/>
                        <a:gd name="connsiteX16" fmla="*/ 43391 w 485752"/>
                        <a:gd name="connsiteY16" fmla="*/ 208275 h 277700"/>
                        <a:gd name="connsiteX17" fmla="*/ 43391 w 485752"/>
                        <a:gd name="connsiteY17" fmla="*/ 69425 h 2777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</a:cxnLst>
                      <a:rect l="l" t="t" r="r" b="b"/>
                      <a:pathLst>
                        <a:path w="485752" h="277700" fill="none" extrusionOk="0">
                          <a:moveTo>
                            <a:pt x="0" y="69425"/>
                          </a:moveTo>
                          <a:cubicBezTo>
                            <a:pt x="2574" y="68951"/>
                            <a:pt x="5634" y="69613"/>
                            <a:pt x="8678" y="69425"/>
                          </a:cubicBezTo>
                          <a:cubicBezTo>
                            <a:pt x="11807" y="115999"/>
                            <a:pt x="-3793" y="160308"/>
                            <a:pt x="8678" y="208275"/>
                          </a:cubicBezTo>
                          <a:cubicBezTo>
                            <a:pt x="5116" y="209135"/>
                            <a:pt x="2811" y="207369"/>
                            <a:pt x="0" y="208275"/>
                          </a:cubicBezTo>
                          <a:cubicBezTo>
                            <a:pt x="-9565" y="158597"/>
                            <a:pt x="9530" y="112657"/>
                            <a:pt x="0" y="69425"/>
                          </a:cubicBezTo>
                          <a:close/>
                          <a:moveTo>
                            <a:pt x="17356" y="69425"/>
                          </a:moveTo>
                          <a:cubicBezTo>
                            <a:pt x="24159" y="67405"/>
                            <a:pt x="27155" y="70947"/>
                            <a:pt x="34713" y="69425"/>
                          </a:cubicBezTo>
                          <a:cubicBezTo>
                            <a:pt x="38387" y="121109"/>
                            <a:pt x="34208" y="140394"/>
                            <a:pt x="34713" y="208275"/>
                          </a:cubicBezTo>
                          <a:cubicBezTo>
                            <a:pt x="28958" y="209764"/>
                            <a:pt x="23259" y="207825"/>
                            <a:pt x="17356" y="208275"/>
                          </a:cubicBezTo>
                          <a:cubicBezTo>
                            <a:pt x="9681" y="139410"/>
                            <a:pt x="18890" y="113226"/>
                            <a:pt x="17356" y="69425"/>
                          </a:cubicBezTo>
                          <a:close/>
                          <a:moveTo>
                            <a:pt x="43391" y="69425"/>
                          </a:moveTo>
                          <a:cubicBezTo>
                            <a:pt x="175231" y="56057"/>
                            <a:pt x="224933" y="103866"/>
                            <a:pt x="346902" y="69425"/>
                          </a:cubicBezTo>
                          <a:cubicBezTo>
                            <a:pt x="342141" y="42923"/>
                            <a:pt x="352461" y="29671"/>
                            <a:pt x="346902" y="0"/>
                          </a:cubicBezTo>
                          <a:cubicBezTo>
                            <a:pt x="413096" y="59982"/>
                            <a:pt x="405512" y="82487"/>
                            <a:pt x="485752" y="138850"/>
                          </a:cubicBezTo>
                          <a:cubicBezTo>
                            <a:pt x="467893" y="188310"/>
                            <a:pt x="366440" y="234451"/>
                            <a:pt x="346902" y="277700"/>
                          </a:cubicBezTo>
                          <a:cubicBezTo>
                            <a:pt x="343444" y="244588"/>
                            <a:pt x="349773" y="240915"/>
                            <a:pt x="346902" y="208275"/>
                          </a:cubicBezTo>
                          <a:cubicBezTo>
                            <a:pt x="261072" y="241287"/>
                            <a:pt x="163071" y="202554"/>
                            <a:pt x="43391" y="208275"/>
                          </a:cubicBezTo>
                          <a:cubicBezTo>
                            <a:pt x="31513" y="169116"/>
                            <a:pt x="45476" y="109959"/>
                            <a:pt x="43391" y="69425"/>
                          </a:cubicBezTo>
                          <a:close/>
                        </a:path>
                        <a:path w="485752" h="277700" stroke="0" extrusionOk="0">
                          <a:moveTo>
                            <a:pt x="0" y="69425"/>
                          </a:moveTo>
                          <a:cubicBezTo>
                            <a:pt x="3176" y="68911"/>
                            <a:pt x="4839" y="69957"/>
                            <a:pt x="8678" y="69425"/>
                          </a:cubicBezTo>
                          <a:cubicBezTo>
                            <a:pt x="13035" y="113698"/>
                            <a:pt x="-2106" y="146927"/>
                            <a:pt x="8678" y="208275"/>
                          </a:cubicBezTo>
                          <a:cubicBezTo>
                            <a:pt x="5936" y="208734"/>
                            <a:pt x="2984" y="207435"/>
                            <a:pt x="0" y="208275"/>
                          </a:cubicBezTo>
                          <a:cubicBezTo>
                            <a:pt x="-5725" y="159888"/>
                            <a:pt x="8467" y="117642"/>
                            <a:pt x="0" y="69425"/>
                          </a:cubicBezTo>
                          <a:close/>
                          <a:moveTo>
                            <a:pt x="17356" y="69425"/>
                          </a:moveTo>
                          <a:cubicBezTo>
                            <a:pt x="21890" y="67748"/>
                            <a:pt x="27926" y="70500"/>
                            <a:pt x="34713" y="69425"/>
                          </a:cubicBezTo>
                          <a:cubicBezTo>
                            <a:pt x="37378" y="121010"/>
                            <a:pt x="24822" y="167879"/>
                            <a:pt x="34713" y="208275"/>
                          </a:cubicBezTo>
                          <a:cubicBezTo>
                            <a:pt x="29303" y="210030"/>
                            <a:pt x="22330" y="206251"/>
                            <a:pt x="17356" y="208275"/>
                          </a:cubicBezTo>
                          <a:cubicBezTo>
                            <a:pt x="6188" y="180350"/>
                            <a:pt x="24594" y="100040"/>
                            <a:pt x="17356" y="69425"/>
                          </a:cubicBezTo>
                          <a:close/>
                          <a:moveTo>
                            <a:pt x="43391" y="69425"/>
                          </a:moveTo>
                          <a:cubicBezTo>
                            <a:pt x="165772" y="68858"/>
                            <a:pt x="219253" y="78350"/>
                            <a:pt x="346902" y="69425"/>
                          </a:cubicBezTo>
                          <a:cubicBezTo>
                            <a:pt x="343409" y="36923"/>
                            <a:pt x="347985" y="19818"/>
                            <a:pt x="346902" y="0"/>
                          </a:cubicBezTo>
                          <a:cubicBezTo>
                            <a:pt x="413372" y="62129"/>
                            <a:pt x="437906" y="103090"/>
                            <a:pt x="485752" y="138850"/>
                          </a:cubicBezTo>
                          <a:cubicBezTo>
                            <a:pt x="459647" y="171217"/>
                            <a:pt x="403624" y="202933"/>
                            <a:pt x="346902" y="277700"/>
                          </a:cubicBezTo>
                          <a:cubicBezTo>
                            <a:pt x="339568" y="253097"/>
                            <a:pt x="348790" y="228404"/>
                            <a:pt x="346902" y="208275"/>
                          </a:cubicBezTo>
                          <a:cubicBezTo>
                            <a:pt x="211647" y="244053"/>
                            <a:pt x="148055" y="198970"/>
                            <a:pt x="43391" y="208275"/>
                          </a:cubicBezTo>
                          <a:cubicBezTo>
                            <a:pt x="39696" y="162750"/>
                            <a:pt x="56462" y="118913"/>
                            <a:pt x="43391" y="69425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6" name="Flecha a la derecha con bandas 15">
              <a:extLst>
                <a:ext uri="{FF2B5EF4-FFF2-40B4-BE49-F238E27FC236}">
                  <a16:creationId xmlns="" xmlns:a16="http://schemas.microsoft.com/office/drawing/2014/main" id="{FD107C22-C748-D44B-B36B-0E2ED2303E9B}"/>
                </a:ext>
              </a:extLst>
            </p:cNvPr>
            <p:cNvSpPr/>
            <p:nvPr/>
          </p:nvSpPr>
          <p:spPr>
            <a:xfrm rot="746135">
              <a:off x="9598048" y="3938440"/>
              <a:ext cx="485752" cy="277700"/>
            </a:xfrm>
            <a:prstGeom prst="stripedRightArrow">
              <a:avLst/>
            </a:prstGeom>
            <a:solidFill>
              <a:srgbClr val="F9BB32"/>
            </a:solidFill>
            <a:ln>
              <a:noFill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0 w 485752"/>
                        <a:gd name="connsiteY0" fmla="*/ 69425 h 277700"/>
                        <a:gd name="connsiteX1" fmla="*/ 8678 w 485752"/>
                        <a:gd name="connsiteY1" fmla="*/ 69425 h 277700"/>
                        <a:gd name="connsiteX2" fmla="*/ 8678 w 485752"/>
                        <a:gd name="connsiteY2" fmla="*/ 208275 h 277700"/>
                        <a:gd name="connsiteX3" fmla="*/ 0 w 485752"/>
                        <a:gd name="connsiteY3" fmla="*/ 208275 h 277700"/>
                        <a:gd name="connsiteX4" fmla="*/ 0 w 485752"/>
                        <a:gd name="connsiteY4" fmla="*/ 69425 h 277700"/>
                        <a:gd name="connsiteX5" fmla="*/ 17356 w 485752"/>
                        <a:gd name="connsiteY5" fmla="*/ 69425 h 277700"/>
                        <a:gd name="connsiteX6" fmla="*/ 34713 w 485752"/>
                        <a:gd name="connsiteY6" fmla="*/ 69425 h 277700"/>
                        <a:gd name="connsiteX7" fmla="*/ 34713 w 485752"/>
                        <a:gd name="connsiteY7" fmla="*/ 208275 h 277700"/>
                        <a:gd name="connsiteX8" fmla="*/ 17356 w 485752"/>
                        <a:gd name="connsiteY8" fmla="*/ 208275 h 277700"/>
                        <a:gd name="connsiteX9" fmla="*/ 17356 w 485752"/>
                        <a:gd name="connsiteY9" fmla="*/ 69425 h 277700"/>
                        <a:gd name="connsiteX10" fmla="*/ 43391 w 485752"/>
                        <a:gd name="connsiteY10" fmla="*/ 69425 h 277700"/>
                        <a:gd name="connsiteX11" fmla="*/ 346902 w 485752"/>
                        <a:gd name="connsiteY11" fmla="*/ 69425 h 277700"/>
                        <a:gd name="connsiteX12" fmla="*/ 346902 w 485752"/>
                        <a:gd name="connsiteY12" fmla="*/ 0 h 277700"/>
                        <a:gd name="connsiteX13" fmla="*/ 485752 w 485752"/>
                        <a:gd name="connsiteY13" fmla="*/ 138850 h 277700"/>
                        <a:gd name="connsiteX14" fmla="*/ 346902 w 485752"/>
                        <a:gd name="connsiteY14" fmla="*/ 277700 h 277700"/>
                        <a:gd name="connsiteX15" fmla="*/ 346902 w 485752"/>
                        <a:gd name="connsiteY15" fmla="*/ 208275 h 277700"/>
                        <a:gd name="connsiteX16" fmla="*/ 43391 w 485752"/>
                        <a:gd name="connsiteY16" fmla="*/ 208275 h 277700"/>
                        <a:gd name="connsiteX17" fmla="*/ 43391 w 485752"/>
                        <a:gd name="connsiteY17" fmla="*/ 69425 h 2777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</a:cxnLst>
                      <a:rect l="l" t="t" r="r" b="b"/>
                      <a:pathLst>
                        <a:path w="485752" h="277700" fill="none" extrusionOk="0">
                          <a:moveTo>
                            <a:pt x="0" y="69425"/>
                          </a:moveTo>
                          <a:cubicBezTo>
                            <a:pt x="2574" y="68951"/>
                            <a:pt x="5634" y="69613"/>
                            <a:pt x="8678" y="69425"/>
                          </a:cubicBezTo>
                          <a:cubicBezTo>
                            <a:pt x="11807" y="115999"/>
                            <a:pt x="-3793" y="160308"/>
                            <a:pt x="8678" y="208275"/>
                          </a:cubicBezTo>
                          <a:cubicBezTo>
                            <a:pt x="5116" y="209135"/>
                            <a:pt x="2811" y="207369"/>
                            <a:pt x="0" y="208275"/>
                          </a:cubicBezTo>
                          <a:cubicBezTo>
                            <a:pt x="-9565" y="158597"/>
                            <a:pt x="9530" y="112657"/>
                            <a:pt x="0" y="69425"/>
                          </a:cubicBezTo>
                          <a:close/>
                          <a:moveTo>
                            <a:pt x="17356" y="69425"/>
                          </a:moveTo>
                          <a:cubicBezTo>
                            <a:pt x="24159" y="67405"/>
                            <a:pt x="27155" y="70947"/>
                            <a:pt x="34713" y="69425"/>
                          </a:cubicBezTo>
                          <a:cubicBezTo>
                            <a:pt x="38387" y="121109"/>
                            <a:pt x="34208" y="140394"/>
                            <a:pt x="34713" y="208275"/>
                          </a:cubicBezTo>
                          <a:cubicBezTo>
                            <a:pt x="28958" y="209764"/>
                            <a:pt x="23259" y="207825"/>
                            <a:pt x="17356" y="208275"/>
                          </a:cubicBezTo>
                          <a:cubicBezTo>
                            <a:pt x="9681" y="139410"/>
                            <a:pt x="18890" y="113226"/>
                            <a:pt x="17356" y="69425"/>
                          </a:cubicBezTo>
                          <a:close/>
                          <a:moveTo>
                            <a:pt x="43391" y="69425"/>
                          </a:moveTo>
                          <a:cubicBezTo>
                            <a:pt x="175231" y="56057"/>
                            <a:pt x="224933" y="103866"/>
                            <a:pt x="346902" y="69425"/>
                          </a:cubicBezTo>
                          <a:cubicBezTo>
                            <a:pt x="342141" y="42923"/>
                            <a:pt x="352461" y="29671"/>
                            <a:pt x="346902" y="0"/>
                          </a:cubicBezTo>
                          <a:cubicBezTo>
                            <a:pt x="413096" y="59982"/>
                            <a:pt x="405512" y="82487"/>
                            <a:pt x="485752" y="138850"/>
                          </a:cubicBezTo>
                          <a:cubicBezTo>
                            <a:pt x="467893" y="188310"/>
                            <a:pt x="366440" y="234451"/>
                            <a:pt x="346902" y="277700"/>
                          </a:cubicBezTo>
                          <a:cubicBezTo>
                            <a:pt x="343444" y="244588"/>
                            <a:pt x="349773" y="240915"/>
                            <a:pt x="346902" y="208275"/>
                          </a:cubicBezTo>
                          <a:cubicBezTo>
                            <a:pt x="261072" y="241287"/>
                            <a:pt x="163071" y="202554"/>
                            <a:pt x="43391" y="208275"/>
                          </a:cubicBezTo>
                          <a:cubicBezTo>
                            <a:pt x="31513" y="169116"/>
                            <a:pt x="45476" y="109959"/>
                            <a:pt x="43391" y="69425"/>
                          </a:cubicBezTo>
                          <a:close/>
                        </a:path>
                        <a:path w="485752" h="277700" stroke="0" extrusionOk="0">
                          <a:moveTo>
                            <a:pt x="0" y="69425"/>
                          </a:moveTo>
                          <a:cubicBezTo>
                            <a:pt x="3176" y="68911"/>
                            <a:pt x="4839" y="69957"/>
                            <a:pt x="8678" y="69425"/>
                          </a:cubicBezTo>
                          <a:cubicBezTo>
                            <a:pt x="13035" y="113698"/>
                            <a:pt x="-2106" y="146927"/>
                            <a:pt x="8678" y="208275"/>
                          </a:cubicBezTo>
                          <a:cubicBezTo>
                            <a:pt x="5936" y="208734"/>
                            <a:pt x="2984" y="207435"/>
                            <a:pt x="0" y="208275"/>
                          </a:cubicBezTo>
                          <a:cubicBezTo>
                            <a:pt x="-5725" y="159888"/>
                            <a:pt x="8467" y="117642"/>
                            <a:pt x="0" y="69425"/>
                          </a:cubicBezTo>
                          <a:close/>
                          <a:moveTo>
                            <a:pt x="17356" y="69425"/>
                          </a:moveTo>
                          <a:cubicBezTo>
                            <a:pt x="21890" y="67748"/>
                            <a:pt x="27926" y="70500"/>
                            <a:pt x="34713" y="69425"/>
                          </a:cubicBezTo>
                          <a:cubicBezTo>
                            <a:pt x="37378" y="121010"/>
                            <a:pt x="24822" y="167879"/>
                            <a:pt x="34713" y="208275"/>
                          </a:cubicBezTo>
                          <a:cubicBezTo>
                            <a:pt x="29303" y="210030"/>
                            <a:pt x="22330" y="206251"/>
                            <a:pt x="17356" y="208275"/>
                          </a:cubicBezTo>
                          <a:cubicBezTo>
                            <a:pt x="6188" y="180350"/>
                            <a:pt x="24594" y="100040"/>
                            <a:pt x="17356" y="69425"/>
                          </a:cubicBezTo>
                          <a:close/>
                          <a:moveTo>
                            <a:pt x="43391" y="69425"/>
                          </a:moveTo>
                          <a:cubicBezTo>
                            <a:pt x="165772" y="68858"/>
                            <a:pt x="219253" y="78350"/>
                            <a:pt x="346902" y="69425"/>
                          </a:cubicBezTo>
                          <a:cubicBezTo>
                            <a:pt x="343409" y="36923"/>
                            <a:pt x="347985" y="19818"/>
                            <a:pt x="346902" y="0"/>
                          </a:cubicBezTo>
                          <a:cubicBezTo>
                            <a:pt x="413372" y="62129"/>
                            <a:pt x="437906" y="103090"/>
                            <a:pt x="485752" y="138850"/>
                          </a:cubicBezTo>
                          <a:cubicBezTo>
                            <a:pt x="459647" y="171217"/>
                            <a:pt x="403624" y="202933"/>
                            <a:pt x="346902" y="277700"/>
                          </a:cubicBezTo>
                          <a:cubicBezTo>
                            <a:pt x="339568" y="253097"/>
                            <a:pt x="348790" y="228404"/>
                            <a:pt x="346902" y="208275"/>
                          </a:cubicBezTo>
                          <a:cubicBezTo>
                            <a:pt x="211647" y="244053"/>
                            <a:pt x="148055" y="198970"/>
                            <a:pt x="43391" y="208275"/>
                          </a:cubicBezTo>
                          <a:cubicBezTo>
                            <a:pt x="39696" y="162750"/>
                            <a:pt x="56462" y="118913"/>
                            <a:pt x="43391" y="69425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27" name="Flecha a la derecha con bandas 16">
              <a:extLst>
                <a:ext uri="{FF2B5EF4-FFF2-40B4-BE49-F238E27FC236}">
                  <a16:creationId xmlns="" xmlns:a16="http://schemas.microsoft.com/office/drawing/2014/main" id="{FEF19348-BA03-B54B-8AF9-803C8656D833}"/>
                </a:ext>
              </a:extLst>
            </p:cNvPr>
            <p:cNvSpPr/>
            <p:nvPr/>
          </p:nvSpPr>
          <p:spPr>
            <a:xfrm rot="5400000">
              <a:off x="8567801" y="4347725"/>
              <a:ext cx="485752" cy="277700"/>
            </a:xfrm>
            <a:prstGeom prst="stripedRightArrow">
              <a:avLst/>
            </a:prstGeom>
            <a:solidFill>
              <a:srgbClr val="F9BB32"/>
            </a:solidFill>
            <a:ln>
              <a:noFill/>
              <a:extLst>
                <a:ext uri="{C807C97D-BFC1-408E-A445-0C87EB9F89A2}">
                  <ask:lineSketchStyleProps xmlns="" xmlns:ask="http://schemas.microsoft.com/office/drawing/2018/sketchyshapes" sd="1219033472">
                    <a:custGeom>
                      <a:avLst/>
                      <a:gdLst>
                        <a:gd name="connsiteX0" fmla="*/ 0 w 485752"/>
                        <a:gd name="connsiteY0" fmla="*/ 69425 h 277700"/>
                        <a:gd name="connsiteX1" fmla="*/ 8678 w 485752"/>
                        <a:gd name="connsiteY1" fmla="*/ 69425 h 277700"/>
                        <a:gd name="connsiteX2" fmla="*/ 8678 w 485752"/>
                        <a:gd name="connsiteY2" fmla="*/ 208275 h 277700"/>
                        <a:gd name="connsiteX3" fmla="*/ 0 w 485752"/>
                        <a:gd name="connsiteY3" fmla="*/ 208275 h 277700"/>
                        <a:gd name="connsiteX4" fmla="*/ 0 w 485752"/>
                        <a:gd name="connsiteY4" fmla="*/ 69425 h 277700"/>
                        <a:gd name="connsiteX5" fmla="*/ 17356 w 485752"/>
                        <a:gd name="connsiteY5" fmla="*/ 69425 h 277700"/>
                        <a:gd name="connsiteX6" fmla="*/ 34713 w 485752"/>
                        <a:gd name="connsiteY6" fmla="*/ 69425 h 277700"/>
                        <a:gd name="connsiteX7" fmla="*/ 34713 w 485752"/>
                        <a:gd name="connsiteY7" fmla="*/ 208275 h 277700"/>
                        <a:gd name="connsiteX8" fmla="*/ 17356 w 485752"/>
                        <a:gd name="connsiteY8" fmla="*/ 208275 h 277700"/>
                        <a:gd name="connsiteX9" fmla="*/ 17356 w 485752"/>
                        <a:gd name="connsiteY9" fmla="*/ 69425 h 277700"/>
                        <a:gd name="connsiteX10" fmla="*/ 43391 w 485752"/>
                        <a:gd name="connsiteY10" fmla="*/ 69425 h 277700"/>
                        <a:gd name="connsiteX11" fmla="*/ 346902 w 485752"/>
                        <a:gd name="connsiteY11" fmla="*/ 69425 h 277700"/>
                        <a:gd name="connsiteX12" fmla="*/ 346902 w 485752"/>
                        <a:gd name="connsiteY12" fmla="*/ 0 h 277700"/>
                        <a:gd name="connsiteX13" fmla="*/ 485752 w 485752"/>
                        <a:gd name="connsiteY13" fmla="*/ 138850 h 277700"/>
                        <a:gd name="connsiteX14" fmla="*/ 346902 w 485752"/>
                        <a:gd name="connsiteY14" fmla="*/ 277700 h 277700"/>
                        <a:gd name="connsiteX15" fmla="*/ 346902 w 485752"/>
                        <a:gd name="connsiteY15" fmla="*/ 208275 h 277700"/>
                        <a:gd name="connsiteX16" fmla="*/ 43391 w 485752"/>
                        <a:gd name="connsiteY16" fmla="*/ 208275 h 277700"/>
                        <a:gd name="connsiteX17" fmla="*/ 43391 w 485752"/>
                        <a:gd name="connsiteY17" fmla="*/ 69425 h 277700"/>
                      </a:gdLst>
                      <a:ahLst/>
                      <a:cxnLst>
                        <a:cxn ang="0">
                          <a:pos x="connsiteX0" y="connsiteY0"/>
                        </a:cxn>
                        <a:cxn ang="0">
                          <a:pos x="connsiteX1" y="connsiteY1"/>
                        </a:cxn>
                        <a:cxn ang="0">
                          <a:pos x="connsiteX2" y="connsiteY2"/>
                        </a:cxn>
                        <a:cxn ang="0">
                          <a:pos x="connsiteX3" y="connsiteY3"/>
                        </a:cxn>
                        <a:cxn ang="0">
                          <a:pos x="connsiteX4" y="connsiteY4"/>
                        </a:cxn>
                        <a:cxn ang="0">
                          <a:pos x="connsiteX5" y="connsiteY5"/>
                        </a:cxn>
                        <a:cxn ang="0">
                          <a:pos x="connsiteX6" y="connsiteY6"/>
                        </a:cxn>
                        <a:cxn ang="0">
                          <a:pos x="connsiteX7" y="connsiteY7"/>
                        </a:cxn>
                        <a:cxn ang="0">
                          <a:pos x="connsiteX8" y="connsiteY8"/>
                        </a:cxn>
                        <a:cxn ang="0">
                          <a:pos x="connsiteX9" y="connsiteY9"/>
                        </a:cxn>
                        <a:cxn ang="0">
                          <a:pos x="connsiteX10" y="connsiteY10"/>
                        </a:cxn>
                        <a:cxn ang="0">
                          <a:pos x="connsiteX11" y="connsiteY11"/>
                        </a:cxn>
                        <a:cxn ang="0">
                          <a:pos x="connsiteX12" y="connsiteY12"/>
                        </a:cxn>
                        <a:cxn ang="0">
                          <a:pos x="connsiteX13" y="connsiteY13"/>
                        </a:cxn>
                        <a:cxn ang="0">
                          <a:pos x="connsiteX14" y="connsiteY14"/>
                        </a:cxn>
                        <a:cxn ang="0">
                          <a:pos x="connsiteX15" y="connsiteY15"/>
                        </a:cxn>
                        <a:cxn ang="0">
                          <a:pos x="connsiteX16" y="connsiteY16"/>
                        </a:cxn>
                        <a:cxn ang="0">
                          <a:pos x="connsiteX17" y="connsiteY17"/>
                        </a:cxn>
                      </a:cxnLst>
                      <a:rect l="l" t="t" r="r" b="b"/>
                      <a:pathLst>
                        <a:path w="485752" h="277700" fill="none" extrusionOk="0">
                          <a:moveTo>
                            <a:pt x="0" y="69425"/>
                          </a:moveTo>
                          <a:cubicBezTo>
                            <a:pt x="2574" y="68951"/>
                            <a:pt x="5634" y="69613"/>
                            <a:pt x="8678" y="69425"/>
                          </a:cubicBezTo>
                          <a:cubicBezTo>
                            <a:pt x="11807" y="115999"/>
                            <a:pt x="-3793" y="160308"/>
                            <a:pt x="8678" y="208275"/>
                          </a:cubicBezTo>
                          <a:cubicBezTo>
                            <a:pt x="5116" y="209135"/>
                            <a:pt x="2811" y="207369"/>
                            <a:pt x="0" y="208275"/>
                          </a:cubicBezTo>
                          <a:cubicBezTo>
                            <a:pt x="-9565" y="158597"/>
                            <a:pt x="9530" y="112657"/>
                            <a:pt x="0" y="69425"/>
                          </a:cubicBezTo>
                          <a:close/>
                          <a:moveTo>
                            <a:pt x="17356" y="69425"/>
                          </a:moveTo>
                          <a:cubicBezTo>
                            <a:pt x="24159" y="67405"/>
                            <a:pt x="27155" y="70947"/>
                            <a:pt x="34713" y="69425"/>
                          </a:cubicBezTo>
                          <a:cubicBezTo>
                            <a:pt x="38387" y="121109"/>
                            <a:pt x="34208" y="140394"/>
                            <a:pt x="34713" y="208275"/>
                          </a:cubicBezTo>
                          <a:cubicBezTo>
                            <a:pt x="28958" y="209764"/>
                            <a:pt x="23259" y="207825"/>
                            <a:pt x="17356" y="208275"/>
                          </a:cubicBezTo>
                          <a:cubicBezTo>
                            <a:pt x="9681" y="139410"/>
                            <a:pt x="18890" y="113226"/>
                            <a:pt x="17356" y="69425"/>
                          </a:cubicBezTo>
                          <a:close/>
                          <a:moveTo>
                            <a:pt x="43391" y="69425"/>
                          </a:moveTo>
                          <a:cubicBezTo>
                            <a:pt x="175231" y="56057"/>
                            <a:pt x="224933" y="103866"/>
                            <a:pt x="346902" y="69425"/>
                          </a:cubicBezTo>
                          <a:cubicBezTo>
                            <a:pt x="342141" y="42923"/>
                            <a:pt x="352461" y="29671"/>
                            <a:pt x="346902" y="0"/>
                          </a:cubicBezTo>
                          <a:cubicBezTo>
                            <a:pt x="413096" y="59982"/>
                            <a:pt x="405512" y="82487"/>
                            <a:pt x="485752" y="138850"/>
                          </a:cubicBezTo>
                          <a:cubicBezTo>
                            <a:pt x="467893" y="188310"/>
                            <a:pt x="366440" y="234451"/>
                            <a:pt x="346902" y="277700"/>
                          </a:cubicBezTo>
                          <a:cubicBezTo>
                            <a:pt x="343444" y="244588"/>
                            <a:pt x="349773" y="240915"/>
                            <a:pt x="346902" y="208275"/>
                          </a:cubicBezTo>
                          <a:cubicBezTo>
                            <a:pt x="261072" y="241287"/>
                            <a:pt x="163071" y="202554"/>
                            <a:pt x="43391" y="208275"/>
                          </a:cubicBezTo>
                          <a:cubicBezTo>
                            <a:pt x="31513" y="169116"/>
                            <a:pt x="45476" y="109959"/>
                            <a:pt x="43391" y="69425"/>
                          </a:cubicBezTo>
                          <a:close/>
                        </a:path>
                        <a:path w="485752" h="277700" stroke="0" extrusionOk="0">
                          <a:moveTo>
                            <a:pt x="0" y="69425"/>
                          </a:moveTo>
                          <a:cubicBezTo>
                            <a:pt x="3176" y="68911"/>
                            <a:pt x="4839" y="69957"/>
                            <a:pt x="8678" y="69425"/>
                          </a:cubicBezTo>
                          <a:cubicBezTo>
                            <a:pt x="13035" y="113698"/>
                            <a:pt x="-2106" y="146927"/>
                            <a:pt x="8678" y="208275"/>
                          </a:cubicBezTo>
                          <a:cubicBezTo>
                            <a:pt x="5936" y="208734"/>
                            <a:pt x="2984" y="207435"/>
                            <a:pt x="0" y="208275"/>
                          </a:cubicBezTo>
                          <a:cubicBezTo>
                            <a:pt x="-5725" y="159888"/>
                            <a:pt x="8467" y="117642"/>
                            <a:pt x="0" y="69425"/>
                          </a:cubicBezTo>
                          <a:close/>
                          <a:moveTo>
                            <a:pt x="17356" y="69425"/>
                          </a:moveTo>
                          <a:cubicBezTo>
                            <a:pt x="21890" y="67748"/>
                            <a:pt x="27926" y="70500"/>
                            <a:pt x="34713" y="69425"/>
                          </a:cubicBezTo>
                          <a:cubicBezTo>
                            <a:pt x="37378" y="121010"/>
                            <a:pt x="24822" y="167879"/>
                            <a:pt x="34713" y="208275"/>
                          </a:cubicBezTo>
                          <a:cubicBezTo>
                            <a:pt x="29303" y="210030"/>
                            <a:pt x="22330" y="206251"/>
                            <a:pt x="17356" y="208275"/>
                          </a:cubicBezTo>
                          <a:cubicBezTo>
                            <a:pt x="6188" y="180350"/>
                            <a:pt x="24594" y="100040"/>
                            <a:pt x="17356" y="69425"/>
                          </a:cubicBezTo>
                          <a:close/>
                          <a:moveTo>
                            <a:pt x="43391" y="69425"/>
                          </a:moveTo>
                          <a:cubicBezTo>
                            <a:pt x="165772" y="68858"/>
                            <a:pt x="219253" y="78350"/>
                            <a:pt x="346902" y="69425"/>
                          </a:cubicBezTo>
                          <a:cubicBezTo>
                            <a:pt x="343409" y="36923"/>
                            <a:pt x="347985" y="19818"/>
                            <a:pt x="346902" y="0"/>
                          </a:cubicBezTo>
                          <a:cubicBezTo>
                            <a:pt x="413372" y="62129"/>
                            <a:pt x="437906" y="103090"/>
                            <a:pt x="485752" y="138850"/>
                          </a:cubicBezTo>
                          <a:cubicBezTo>
                            <a:pt x="459647" y="171217"/>
                            <a:pt x="403624" y="202933"/>
                            <a:pt x="346902" y="277700"/>
                          </a:cubicBezTo>
                          <a:cubicBezTo>
                            <a:pt x="339568" y="253097"/>
                            <a:pt x="348790" y="228404"/>
                            <a:pt x="346902" y="208275"/>
                          </a:cubicBezTo>
                          <a:cubicBezTo>
                            <a:pt x="211647" y="244053"/>
                            <a:pt x="148055" y="198970"/>
                            <a:pt x="43391" y="208275"/>
                          </a:cubicBezTo>
                          <a:cubicBezTo>
                            <a:pt x="39696" y="162750"/>
                            <a:pt x="56462" y="118913"/>
                            <a:pt x="43391" y="69425"/>
                          </a:cubicBezTo>
                          <a:close/>
                        </a:path>
                      </a:pathLst>
                    </a:custGeom>
                    <ask:type>
                      <ask:lineSketchNone/>
                    </ask:type>
                  </ask:lineSketchStyleProps>
                </a:ext>
              </a:extLst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pic>
        <p:nvPicPr>
          <p:cNvPr id="28" name="Picture 6" descr="F:\ECCMID 2021\Presentaciones ECCMID 2021\rstudio-og-fb.jpg">
            <a:extLst>
              <a:ext uri="{FF2B5EF4-FFF2-40B4-BE49-F238E27FC236}">
                <a16:creationId xmlns="" xmlns:a16="http://schemas.microsoft.com/office/drawing/2014/main" id="{2EB79CBE-0D41-920D-3644-FFC8563AC6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169092" y="2266441"/>
            <a:ext cx="359676" cy="239335"/>
          </a:xfrm>
          <a:prstGeom prst="rect">
            <a:avLst/>
          </a:prstGeom>
          <a:noFill/>
        </p:spPr>
      </p:pic>
      <p:pic>
        <p:nvPicPr>
          <p:cNvPr id="29" name="Picture 3" descr="F:\ECCMID 2021\Presentaciones ECCMID 2021\0_20210628_135329.jpg">
            <a:extLst>
              <a:ext uri="{FF2B5EF4-FFF2-40B4-BE49-F238E27FC236}">
                <a16:creationId xmlns="" xmlns:a16="http://schemas.microsoft.com/office/drawing/2014/main" id="{A3E16897-8528-5AB7-9D7D-A2DDD4A44F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/>
          <a:srcRect l="27286" t="34944" r="19906" b="30633"/>
          <a:stretch>
            <a:fillRect/>
          </a:stretch>
        </p:blipFill>
        <p:spPr bwMode="auto">
          <a:xfrm rot="5400000">
            <a:off x="2549541" y="1766643"/>
            <a:ext cx="221119" cy="108103"/>
          </a:xfrm>
          <a:prstGeom prst="rect">
            <a:avLst/>
          </a:prstGeom>
          <a:noFill/>
        </p:spPr>
      </p:pic>
      <p:grpSp>
        <p:nvGrpSpPr>
          <p:cNvPr id="30" name="29 Grupo">
            <a:extLst>
              <a:ext uri="{FF2B5EF4-FFF2-40B4-BE49-F238E27FC236}">
                <a16:creationId xmlns="" xmlns:a16="http://schemas.microsoft.com/office/drawing/2014/main" id="{54013C4C-CAA3-ED2C-3FB7-B4369AEEFF7A}"/>
              </a:ext>
            </a:extLst>
          </p:cNvPr>
          <p:cNvGrpSpPr/>
          <p:nvPr/>
        </p:nvGrpSpPr>
        <p:grpSpPr>
          <a:xfrm>
            <a:off x="2819860" y="1696438"/>
            <a:ext cx="887655" cy="373072"/>
            <a:chOff x="3214678" y="4572008"/>
            <a:chExt cx="4286280" cy="1619256"/>
          </a:xfrm>
        </p:grpSpPr>
        <p:sp>
          <p:nvSpPr>
            <p:cNvPr id="31" name="5 Rectángulo">
              <a:extLst>
                <a:ext uri="{FF2B5EF4-FFF2-40B4-BE49-F238E27FC236}">
                  <a16:creationId xmlns="" xmlns:a16="http://schemas.microsoft.com/office/drawing/2014/main" id="{689CC3EE-9FD9-47B7-B59A-C8CE350AA4DD}"/>
                </a:ext>
              </a:extLst>
            </p:cNvPr>
            <p:cNvSpPr/>
            <p:nvPr/>
          </p:nvSpPr>
          <p:spPr>
            <a:xfrm>
              <a:off x="3214678" y="4572008"/>
              <a:ext cx="4286280" cy="428627"/>
            </a:xfrm>
            <a:prstGeom prst="rect">
              <a:avLst/>
            </a:prstGeom>
            <a:solidFill>
              <a:schemeClr val="tx2"/>
            </a:solidFill>
            <a:ln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/>
            </a:p>
          </p:txBody>
        </p:sp>
        <p:sp>
          <p:nvSpPr>
            <p:cNvPr id="32" name="6 Rectángulo">
              <a:extLst>
                <a:ext uri="{FF2B5EF4-FFF2-40B4-BE49-F238E27FC236}">
                  <a16:creationId xmlns="" xmlns:a16="http://schemas.microsoft.com/office/drawing/2014/main" id="{0CCA189F-AA94-2E69-9CFE-C5D1D5A647C4}"/>
                </a:ext>
              </a:extLst>
            </p:cNvPr>
            <p:cNvSpPr/>
            <p:nvPr/>
          </p:nvSpPr>
          <p:spPr>
            <a:xfrm>
              <a:off x="3286116" y="4572008"/>
              <a:ext cx="142876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3" name="7 Rectángulo">
              <a:extLst>
                <a:ext uri="{FF2B5EF4-FFF2-40B4-BE49-F238E27FC236}">
                  <a16:creationId xmlns="" xmlns:a16="http://schemas.microsoft.com/office/drawing/2014/main" id="{D3A14B84-BFFF-F05E-12B6-2E94BC95C3A6}"/>
                </a:ext>
              </a:extLst>
            </p:cNvPr>
            <p:cNvSpPr/>
            <p:nvPr/>
          </p:nvSpPr>
          <p:spPr>
            <a:xfrm>
              <a:off x="3643306" y="4572008"/>
              <a:ext cx="214314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4" name="8 Rectángulo">
              <a:extLst>
                <a:ext uri="{FF2B5EF4-FFF2-40B4-BE49-F238E27FC236}">
                  <a16:creationId xmlns="" xmlns:a16="http://schemas.microsoft.com/office/drawing/2014/main" id="{B91AB53F-2E6D-2235-769D-21FE2A6C50A3}"/>
                </a:ext>
              </a:extLst>
            </p:cNvPr>
            <p:cNvSpPr/>
            <p:nvPr/>
          </p:nvSpPr>
          <p:spPr>
            <a:xfrm>
              <a:off x="4357686" y="4572008"/>
              <a:ext cx="142876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9 Rectángulo">
              <a:extLst>
                <a:ext uri="{FF2B5EF4-FFF2-40B4-BE49-F238E27FC236}">
                  <a16:creationId xmlns="" xmlns:a16="http://schemas.microsoft.com/office/drawing/2014/main" id="{224F167F-26BE-9E76-F2C6-E12B36B704CC}"/>
                </a:ext>
              </a:extLst>
            </p:cNvPr>
            <p:cNvSpPr/>
            <p:nvPr/>
          </p:nvSpPr>
          <p:spPr>
            <a:xfrm>
              <a:off x="4714877" y="4572008"/>
              <a:ext cx="285754" cy="428627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400" smtClean="0"/>
                <a:t>V4</a:t>
              </a:r>
              <a:endParaRPr lang="en-GB" sz="700"/>
            </a:p>
          </p:txBody>
        </p:sp>
        <p:sp>
          <p:nvSpPr>
            <p:cNvPr id="36" name="10 Rectángulo">
              <a:extLst>
                <a:ext uri="{FF2B5EF4-FFF2-40B4-BE49-F238E27FC236}">
                  <a16:creationId xmlns="" xmlns:a16="http://schemas.microsoft.com/office/drawing/2014/main" id="{8F41F10B-AD5C-0116-514E-7FA4325379FE}"/>
                </a:ext>
              </a:extLst>
            </p:cNvPr>
            <p:cNvSpPr/>
            <p:nvPr/>
          </p:nvSpPr>
          <p:spPr>
            <a:xfrm>
              <a:off x="5643570" y="4572008"/>
              <a:ext cx="71438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11 Rectángulo">
              <a:extLst>
                <a:ext uri="{FF2B5EF4-FFF2-40B4-BE49-F238E27FC236}">
                  <a16:creationId xmlns="" xmlns:a16="http://schemas.microsoft.com/office/drawing/2014/main" id="{BA1D7F0A-5F25-4730-A16B-3EDA27255F8F}"/>
                </a:ext>
              </a:extLst>
            </p:cNvPr>
            <p:cNvSpPr/>
            <p:nvPr/>
          </p:nvSpPr>
          <p:spPr>
            <a:xfrm>
              <a:off x="6000760" y="4572008"/>
              <a:ext cx="71438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8" name="12 Rectángulo">
              <a:extLst>
                <a:ext uri="{FF2B5EF4-FFF2-40B4-BE49-F238E27FC236}">
                  <a16:creationId xmlns="" xmlns:a16="http://schemas.microsoft.com/office/drawing/2014/main" id="{ABF6F959-2BAC-B69C-8BB8-8A7114B6ED9B}"/>
                </a:ext>
              </a:extLst>
            </p:cNvPr>
            <p:cNvSpPr/>
            <p:nvPr/>
          </p:nvSpPr>
          <p:spPr>
            <a:xfrm>
              <a:off x="6786578" y="4572008"/>
              <a:ext cx="71438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9" name="13 Rectángulo">
              <a:extLst>
                <a:ext uri="{FF2B5EF4-FFF2-40B4-BE49-F238E27FC236}">
                  <a16:creationId xmlns="" xmlns:a16="http://schemas.microsoft.com/office/drawing/2014/main" id="{94C29FBB-F1BB-7925-186C-A79F10344E7A}"/>
                </a:ext>
              </a:extLst>
            </p:cNvPr>
            <p:cNvSpPr/>
            <p:nvPr/>
          </p:nvSpPr>
          <p:spPr>
            <a:xfrm>
              <a:off x="7072330" y="4572008"/>
              <a:ext cx="71438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0" name="14 Rectángulo">
              <a:extLst>
                <a:ext uri="{FF2B5EF4-FFF2-40B4-BE49-F238E27FC236}">
                  <a16:creationId xmlns="" xmlns:a16="http://schemas.microsoft.com/office/drawing/2014/main" id="{713A27CA-6E50-F9EF-35C1-7644959A8468}"/>
                </a:ext>
              </a:extLst>
            </p:cNvPr>
            <p:cNvSpPr/>
            <p:nvPr/>
          </p:nvSpPr>
          <p:spPr>
            <a:xfrm>
              <a:off x="7358082" y="4572008"/>
              <a:ext cx="71438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1" name="15 Rectángulo">
              <a:extLst>
                <a:ext uri="{FF2B5EF4-FFF2-40B4-BE49-F238E27FC236}">
                  <a16:creationId xmlns="" xmlns:a16="http://schemas.microsoft.com/office/drawing/2014/main" id="{FD1D7C80-21CE-BBC4-BF7B-CE551E9BF58A}"/>
                </a:ext>
              </a:extLst>
            </p:cNvPr>
            <p:cNvSpPr/>
            <p:nvPr/>
          </p:nvSpPr>
          <p:spPr>
            <a:xfrm>
              <a:off x="5572132" y="4572008"/>
              <a:ext cx="71438" cy="42862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16 Rectángulo">
              <a:extLst>
                <a:ext uri="{FF2B5EF4-FFF2-40B4-BE49-F238E27FC236}">
                  <a16:creationId xmlns="" xmlns:a16="http://schemas.microsoft.com/office/drawing/2014/main" id="{DCE81963-CFE0-DCAA-8B48-348B528C21CB}"/>
                </a:ext>
              </a:extLst>
            </p:cNvPr>
            <p:cNvSpPr/>
            <p:nvPr/>
          </p:nvSpPr>
          <p:spPr>
            <a:xfrm>
              <a:off x="3857620" y="5286388"/>
              <a:ext cx="2214578" cy="14287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3" name="17 Rectángulo">
              <a:extLst>
                <a:ext uri="{FF2B5EF4-FFF2-40B4-BE49-F238E27FC236}">
                  <a16:creationId xmlns="" xmlns:a16="http://schemas.microsoft.com/office/drawing/2014/main" id="{52C2BFAE-94F5-6671-4953-DAE6AB8EF2FB}"/>
                </a:ext>
              </a:extLst>
            </p:cNvPr>
            <p:cNvSpPr/>
            <p:nvPr/>
          </p:nvSpPr>
          <p:spPr>
            <a:xfrm>
              <a:off x="3857620" y="5438788"/>
              <a:ext cx="2214578" cy="14287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4" name="18 Rectángulo">
              <a:extLst>
                <a:ext uri="{FF2B5EF4-FFF2-40B4-BE49-F238E27FC236}">
                  <a16:creationId xmlns="" xmlns:a16="http://schemas.microsoft.com/office/drawing/2014/main" id="{F9D55D7A-105F-099A-5A9C-41B5CEC9F663}"/>
                </a:ext>
              </a:extLst>
            </p:cNvPr>
            <p:cNvSpPr/>
            <p:nvPr/>
          </p:nvSpPr>
          <p:spPr>
            <a:xfrm>
              <a:off x="3857620" y="5591188"/>
              <a:ext cx="2214578" cy="14287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" name="19 Rectángulo">
              <a:extLst>
                <a:ext uri="{FF2B5EF4-FFF2-40B4-BE49-F238E27FC236}">
                  <a16:creationId xmlns="" xmlns:a16="http://schemas.microsoft.com/office/drawing/2014/main" id="{D01DCB9D-F090-5D8B-5B5F-D2AEB1540C93}"/>
                </a:ext>
              </a:extLst>
            </p:cNvPr>
            <p:cNvSpPr/>
            <p:nvPr/>
          </p:nvSpPr>
          <p:spPr>
            <a:xfrm>
              <a:off x="3857620" y="5743588"/>
              <a:ext cx="2214578" cy="14287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20 Rectángulo">
              <a:extLst>
                <a:ext uri="{FF2B5EF4-FFF2-40B4-BE49-F238E27FC236}">
                  <a16:creationId xmlns="" xmlns:a16="http://schemas.microsoft.com/office/drawing/2014/main" id="{534F0BE1-5A98-0A01-DA14-131608A14409}"/>
                </a:ext>
              </a:extLst>
            </p:cNvPr>
            <p:cNvSpPr/>
            <p:nvPr/>
          </p:nvSpPr>
          <p:spPr>
            <a:xfrm>
              <a:off x="3857620" y="5895988"/>
              <a:ext cx="2214578" cy="14287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7" name="21 Rectángulo">
              <a:extLst>
                <a:ext uri="{FF2B5EF4-FFF2-40B4-BE49-F238E27FC236}">
                  <a16:creationId xmlns="" xmlns:a16="http://schemas.microsoft.com/office/drawing/2014/main" id="{5533723D-400B-3B9F-94D7-652A59DD9B71}"/>
                </a:ext>
              </a:extLst>
            </p:cNvPr>
            <p:cNvSpPr/>
            <p:nvPr/>
          </p:nvSpPr>
          <p:spPr>
            <a:xfrm>
              <a:off x="3857620" y="6048388"/>
              <a:ext cx="2214578" cy="142876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48" name="23 Conector recto">
              <a:extLst>
                <a:ext uri="{FF2B5EF4-FFF2-40B4-BE49-F238E27FC236}">
                  <a16:creationId xmlns="" xmlns:a16="http://schemas.microsoft.com/office/drawing/2014/main" id="{DEFCC138-F860-0959-6C95-5A2DECA68A3D}"/>
                </a:ext>
              </a:extLst>
            </p:cNvPr>
            <p:cNvCxnSpPr/>
            <p:nvPr/>
          </p:nvCxnSpPr>
          <p:spPr>
            <a:xfrm rot="10800000" flipV="1">
              <a:off x="3929058" y="5072074"/>
              <a:ext cx="785818" cy="142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48 Conector recto">
              <a:extLst>
                <a:ext uri="{FF2B5EF4-FFF2-40B4-BE49-F238E27FC236}">
                  <a16:creationId xmlns="" xmlns:a16="http://schemas.microsoft.com/office/drawing/2014/main" id="{1425EB4C-E183-6723-1CD9-DB033C673899}"/>
                </a:ext>
              </a:extLst>
            </p:cNvPr>
            <p:cNvCxnSpPr/>
            <p:nvPr/>
          </p:nvCxnSpPr>
          <p:spPr>
            <a:xfrm>
              <a:off x="5000628" y="5072074"/>
              <a:ext cx="1071570" cy="14287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0" name="Picture 4" descr="F:\ECCMID 2021\Presentaciones ECCMID 2021\system-carousel-miseq-left.png">
            <a:extLst>
              <a:ext uri="{FF2B5EF4-FFF2-40B4-BE49-F238E27FC236}">
                <a16:creationId xmlns="" xmlns:a16="http://schemas.microsoft.com/office/drawing/2014/main" id="{A4CFE1F2-B350-E3BD-D360-66BB629C17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409012" y="2131066"/>
            <a:ext cx="499614" cy="374710"/>
          </a:xfrm>
          <a:prstGeom prst="rect">
            <a:avLst/>
          </a:prstGeom>
          <a:noFill/>
        </p:spPr>
      </p:pic>
      <p:pic>
        <p:nvPicPr>
          <p:cNvPr id="51" name="Picture 5" descr="F:\ECCMID 2021\Presentaciones ECCMID 2021\mothur_RGB.png">
            <a:extLst>
              <a:ext uri="{FF2B5EF4-FFF2-40B4-BE49-F238E27FC236}">
                <a16:creationId xmlns="" xmlns:a16="http://schemas.microsoft.com/office/drawing/2014/main" id="{F256E8B2-8724-05A3-E249-A2A26F97A2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 flipH="1">
            <a:off x="2946679" y="2173825"/>
            <a:ext cx="180000" cy="180000"/>
          </a:xfrm>
          <a:prstGeom prst="rect">
            <a:avLst/>
          </a:prstGeom>
          <a:noFill/>
        </p:spPr>
      </p:pic>
      <p:pic>
        <p:nvPicPr>
          <p:cNvPr id="52" name="Picture 7" descr="F:\ECCMID 2021\Presentaciones ECCMID 2021\Rlogo.png">
            <a:extLst>
              <a:ext uri="{FF2B5EF4-FFF2-40B4-BE49-F238E27FC236}">
                <a16:creationId xmlns="" xmlns:a16="http://schemas.microsoft.com/office/drawing/2014/main" id="{9C692367-135E-F69F-BD96-E40B14D325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474280" y="2108611"/>
            <a:ext cx="170586" cy="132180"/>
          </a:xfrm>
          <a:prstGeom prst="rect">
            <a:avLst/>
          </a:prstGeom>
          <a:noFill/>
        </p:spPr>
      </p:pic>
      <p:graphicFrame>
        <p:nvGraphicFramePr>
          <p:cNvPr id="53" name="3 Marcador de contenido">
            <a:extLst>
              <a:ext uri="{FF2B5EF4-FFF2-40B4-BE49-F238E27FC236}">
                <a16:creationId xmlns="" xmlns:a16="http://schemas.microsoft.com/office/drawing/2014/main" id="{E75A664F-7382-F7E3-4BC1-5D828CFA2E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506819265"/>
              </p:ext>
            </p:extLst>
          </p:nvPr>
        </p:nvGraphicFramePr>
        <p:xfrm>
          <a:off x="433270" y="1698787"/>
          <a:ext cx="1253453" cy="126257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7" r:lo="rId18" r:qs="rId19" r:cs="rId20"/>
          </a:graphicData>
        </a:graphic>
      </p:graphicFrame>
      <p:sp>
        <p:nvSpPr>
          <p:cNvPr id="54" name="53 Rectángulo"/>
          <p:cNvSpPr/>
          <p:nvPr/>
        </p:nvSpPr>
        <p:spPr>
          <a:xfrm>
            <a:off x="84407" y="2951268"/>
            <a:ext cx="6314537" cy="430887"/>
          </a:xfrm>
          <a:prstGeom prst="rect">
            <a:avLst/>
          </a:prstGeom>
          <a:solidFill>
            <a:schemeClr val="tx2"/>
          </a:solidFill>
        </p:spPr>
        <p:txBody>
          <a:bodyPr wrap="square">
            <a:spAutoFit/>
          </a:bodyPr>
          <a:lstStyle/>
          <a:p>
            <a:r>
              <a:rPr lang="en-GB" sz="1100" b="1" smtClean="0">
                <a:solidFill>
                  <a:schemeClr val="bg1"/>
                </a:solidFill>
                <a:latin typeface="Helvetica"/>
              </a:rPr>
              <a:t>Microbiome profile and calprotectin levels as markers of risk of recurrent </a:t>
            </a:r>
            <a:r>
              <a:rPr lang="en-GB" sz="1100" b="1" i="1" smtClean="0">
                <a:solidFill>
                  <a:schemeClr val="bg1"/>
                </a:solidFill>
                <a:latin typeface="Helvetica"/>
              </a:rPr>
              <a:t>Clostridioides </a:t>
            </a:r>
            <a:r>
              <a:rPr lang="en-GB" sz="1100" b="1" i="1" smtClean="0">
                <a:solidFill>
                  <a:schemeClr val="bg1"/>
                </a:solidFill>
                <a:latin typeface="Helvetica"/>
              </a:rPr>
              <a:t>difficile </a:t>
            </a:r>
            <a:r>
              <a:rPr lang="en-GB" sz="1100" b="1" smtClean="0">
                <a:solidFill>
                  <a:schemeClr val="bg1"/>
                </a:solidFill>
                <a:latin typeface="Helvetica"/>
              </a:rPr>
              <a:t>infection</a:t>
            </a:r>
            <a:endParaRPr lang="en-GB" sz="1100" b="1">
              <a:solidFill>
                <a:schemeClr val="bg1"/>
              </a:solidFill>
              <a:latin typeface="Helvetica"/>
            </a:endParaRPr>
          </a:p>
        </p:txBody>
      </p:sp>
      <p:sp>
        <p:nvSpPr>
          <p:cNvPr id="55" name="54 Rectángulo"/>
          <p:cNvSpPr/>
          <p:nvPr/>
        </p:nvSpPr>
        <p:spPr>
          <a:xfrm>
            <a:off x="84407" y="3331266"/>
            <a:ext cx="6314537" cy="246221"/>
          </a:xfrm>
          <a:prstGeom prst="rect">
            <a:avLst/>
          </a:prstGeom>
          <a:solidFill>
            <a:schemeClr val="tx2"/>
          </a:solidFill>
        </p:spPr>
        <p:txBody>
          <a:bodyPr wrap="square">
            <a:spAutoFit/>
          </a:bodyPr>
          <a:lstStyle/>
          <a:p>
            <a:r>
              <a:rPr lang="en-GB" sz="500" b="1" smtClean="0">
                <a:solidFill>
                  <a:schemeClr val="bg1"/>
                </a:solidFill>
                <a:latin typeface="Helvetica"/>
              </a:rPr>
              <a:t>Silvia Vázquez-Cuesta, Nuria Lozano García, Ana I Fernández, María Olmedo, Martha Kestler, Luis Alcalá, Mercedes Marín, Javier Bermejo, Francisco Fernández-Avilés, Patricia Muñoz, Emilio Bouza and </a:t>
            </a:r>
            <a:r>
              <a:rPr lang="en-GB" sz="500" b="1" smtClean="0">
                <a:solidFill>
                  <a:schemeClr val="bg1"/>
                </a:solidFill>
                <a:latin typeface="Helvetica"/>
              </a:rPr>
              <a:t>Elena </a:t>
            </a:r>
            <a:r>
              <a:rPr lang="en-GB" sz="500" b="1" smtClean="0">
                <a:solidFill>
                  <a:schemeClr val="bg1"/>
                </a:solidFill>
                <a:latin typeface="Helvetica"/>
              </a:rPr>
              <a:t>Reigadas</a:t>
            </a:r>
            <a:endParaRPr lang="en-GB" sz="500" b="1">
              <a:solidFill>
                <a:schemeClr val="bg1"/>
              </a:solidFill>
              <a:latin typeface="Helvetica"/>
            </a:endParaRPr>
          </a:p>
        </p:txBody>
      </p:sp>
      <p:sp>
        <p:nvSpPr>
          <p:cNvPr id="57" name="56 Rectángulo"/>
          <p:cNvSpPr/>
          <p:nvPr/>
        </p:nvSpPr>
        <p:spPr>
          <a:xfrm>
            <a:off x="5641180" y="433947"/>
            <a:ext cx="890562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500" smtClean="0">
                <a:latin typeface="Helvetica"/>
                <a:cs typeface="Times New Roman" pitchFamily="18" charset="0"/>
              </a:rPr>
              <a:t>ROC </a:t>
            </a:r>
            <a:r>
              <a:rPr lang="es-ES" sz="500" smtClean="0">
                <a:latin typeface="Helvetica"/>
                <a:cs typeface="Times New Roman" pitchFamily="18" charset="0"/>
              </a:rPr>
              <a:t>curve </a:t>
            </a:r>
            <a:r>
              <a:rPr lang="es-ES" sz="500" smtClean="0">
                <a:latin typeface="Helvetica"/>
                <a:cs typeface="Times New Roman" pitchFamily="18" charset="0"/>
              </a:rPr>
              <a:t>of </a:t>
            </a:r>
            <a:r>
              <a:rPr lang="es-ES" sz="500" smtClean="0">
                <a:latin typeface="Helvetica"/>
                <a:cs typeface="Times New Roman" pitchFamily="18" charset="0"/>
              </a:rPr>
              <a:t>our model of independent risk factors for developing </a:t>
            </a:r>
            <a:r>
              <a:rPr lang="es-ES" sz="500" smtClean="0">
                <a:latin typeface="Helvetica"/>
                <a:cs typeface="Times New Roman" pitchFamily="18" charset="0"/>
              </a:rPr>
              <a:t>a </a:t>
            </a:r>
            <a:r>
              <a:rPr lang="es-ES" sz="500" smtClean="0">
                <a:latin typeface="Helvetica"/>
                <a:cs typeface="Times New Roman" pitchFamily="18" charset="0"/>
              </a:rPr>
              <a:t>R-CDI:f-calprotectin </a:t>
            </a:r>
            <a:r>
              <a:rPr lang="es-ES" sz="500" smtClean="0">
                <a:latin typeface="Helvetica"/>
                <a:cs typeface="Times New Roman" pitchFamily="18" charset="0"/>
              </a:rPr>
              <a:t>level </a:t>
            </a:r>
            <a:r>
              <a:rPr lang="es-ES" sz="500" smtClean="0">
                <a:latin typeface="Helvetica"/>
                <a:cs typeface="Times New Roman" pitchFamily="18" charset="0"/>
              </a:rPr>
              <a:t>&gt;</a:t>
            </a:r>
            <a:r>
              <a:rPr lang="es-ES" sz="500" smtClean="0">
                <a:latin typeface="Helvetica"/>
                <a:cs typeface="Times New Roman" pitchFamily="18" charset="0"/>
              </a:rPr>
              <a:t>185µg/mg</a:t>
            </a:r>
            <a:r>
              <a:rPr lang="es-ES" sz="500" smtClean="0">
                <a:latin typeface="Helvetica"/>
                <a:cs typeface="Times New Roman" pitchFamily="18" charset="0"/>
              </a:rPr>
              <a:t>, toxin B </a:t>
            </a:r>
            <a:r>
              <a:rPr lang="es-ES" sz="500" smtClean="0">
                <a:latin typeface="Helvetica"/>
                <a:cs typeface="Times New Roman" pitchFamily="18" charset="0"/>
              </a:rPr>
              <a:t>PCR </a:t>
            </a:r>
            <a:r>
              <a:rPr lang="es-ES" sz="500" smtClean="0">
                <a:latin typeface="Helvetica"/>
                <a:cs typeface="Times New Roman" pitchFamily="18" charset="0"/>
              </a:rPr>
              <a:t>cycle &lt;23</a:t>
            </a:r>
            <a:r>
              <a:rPr lang="es-ES" sz="500" smtClean="0">
                <a:latin typeface="Helvetica"/>
                <a:cs typeface="Times New Roman" pitchFamily="18" charset="0"/>
              </a:rPr>
              <a:t>, immunosuppression, female gender, </a:t>
            </a:r>
            <a:r>
              <a:rPr lang="es-ES" sz="500" smtClean="0">
                <a:latin typeface="Helvetica"/>
                <a:cs typeface="Times New Roman" pitchFamily="18" charset="0"/>
              </a:rPr>
              <a:t>age </a:t>
            </a:r>
            <a:r>
              <a:rPr lang="es-ES" sz="500" smtClean="0">
                <a:latin typeface="Helvetica"/>
                <a:cs typeface="Times New Roman" pitchFamily="18" charset="0"/>
              </a:rPr>
              <a:t> &gt;65 years, </a:t>
            </a:r>
            <a:r>
              <a:rPr lang="es-ES" sz="500" smtClean="0">
                <a:latin typeface="Helvetica"/>
                <a:cs typeface="Times New Roman" pitchFamily="18" charset="0"/>
              </a:rPr>
              <a:t>and creatinin </a:t>
            </a:r>
            <a:r>
              <a:rPr lang="es-ES" sz="500" smtClean="0">
                <a:latin typeface="Helvetica"/>
                <a:cs typeface="Times New Roman" pitchFamily="18" charset="0"/>
              </a:rPr>
              <a:t>levels </a:t>
            </a:r>
            <a:r>
              <a:rPr lang="es-ES" sz="500" smtClean="0">
                <a:latin typeface="Helvetica"/>
                <a:cs typeface="Times New Roman" pitchFamily="18" charset="0"/>
              </a:rPr>
              <a:t> &gt;1mg/dL </a:t>
            </a:r>
            <a:r>
              <a:rPr lang="es-ES" sz="500" smtClean="0">
                <a:latin typeface="Helvetica"/>
                <a:cs typeface="Times New Roman" pitchFamily="18" charset="0"/>
              </a:rPr>
              <a:t>(all p&lt;0.05). </a:t>
            </a:r>
            <a:endParaRPr lang="en-GB" sz="500">
              <a:latin typeface="Helvetica"/>
            </a:endParaRPr>
          </a:p>
        </p:txBody>
      </p:sp>
      <p:sp>
        <p:nvSpPr>
          <p:cNvPr id="58" name="57 Rectángulo"/>
          <p:cNvSpPr/>
          <p:nvPr/>
        </p:nvSpPr>
        <p:spPr>
          <a:xfrm>
            <a:off x="5760945" y="1319783"/>
            <a:ext cx="72223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500" smtClean="0">
                <a:latin typeface="Helvetica"/>
                <a:cs typeface="Times New Roman" pitchFamily="18" charset="0"/>
              </a:rPr>
              <a:t>Genus Log2 Fold Change represent differentially abundance genus between groups. recurrent patients vs Non-recurrent patients</a:t>
            </a:r>
            <a:endParaRPr lang="en-GB" sz="500" smtClean="0">
              <a:latin typeface="Helvetica"/>
              <a:cs typeface="Times New Roman" pitchFamily="18" charset="0"/>
            </a:endParaRPr>
          </a:p>
        </p:txBody>
      </p:sp>
      <p:sp>
        <p:nvSpPr>
          <p:cNvPr id="59" name="58 Rectángulo"/>
          <p:cNvSpPr/>
          <p:nvPr/>
        </p:nvSpPr>
        <p:spPr>
          <a:xfrm>
            <a:off x="5766764" y="2134350"/>
            <a:ext cx="764978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500" smtClean="0">
                <a:latin typeface="Helvetica"/>
                <a:cs typeface="Times New Roman" pitchFamily="18" charset="0"/>
              </a:rPr>
              <a:t>Genus Log2 Fold Change represent differentially abundance genus between the following groups: Fecal calprotectin &gt;185𝜇g/mg vs &lt;185𝜇g/mg</a:t>
            </a:r>
            <a:endParaRPr lang="en-GB" sz="500" smtClean="0">
              <a:latin typeface="Helvetica"/>
              <a:cs typeface="Times New Roman" pitchFamily="18" charset="0"/>
            </a:endParaRPr>
          </a:p>
        </p:txBody>
      </p:sp>
      <p:sp>
        <p:nvSpPr>
          <p:cNvPr id="60" name="59 Rectángulo"/>
          <p:cNvSpPr/>
          <p:nvPr/>
        </p:nvSpPr>
        <p:spPr>
          <a:xfrm>
            <a:off x="2606049" y="1334615"/>
            <a:ext cx="1223742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500" smtClean="0">
                <a:latin typeface="Helvetica"/>
                <a:cs typeface="Times New Roman" pitchFamily="18" charset="0"/>
              </a:rPr>
              <a:t>Measure of fecal calprotectin levels</a:t>
            </a:r>
            <a:endParaRPr lang="en-GB" sz="500">
              <a:latin typeface="Helvetica"/>
            </a:endParaRPr>
          </a:p>
        </p:txBody>
      </p:sp>
      <p:sp>
        <p:nvSpPr>
          <p:cNvPr id="61" name="60 Rectángulo"/>
          <p:cNvSpPr/>
          <p:nvPr/>
        </p:nvSpPr>
        <p:spPr>
          <a:xfrm>
            <a:off x="2550497" y="2505776"/>
            <a:ext cx="1279293" cy="1692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500" smtClean="0">
                <a:latin typeface="Helvetica"/>
                <a:cs typeface="Times New Roman" pitchFamily="18" charset="0"/>
              </a:rPr>
              <a:t>16S rRNA gene V4 region sequences.</a:t>
            </a:r>
            <a:endParaRPr lang="en-GB" sz="500">
              <a:latin typeface="Helvetica"/>
            </a:endParaRPr>
          </a:p>
        </p:txBody>
      </p:sp>
      <p:sp>
        <p:nvSpPr>
          <p:cNvPr id="65" name="64 Rectángulo"/>
          <p:cNvSpPr/>
          <p:nvPr/>
        </p:nvSpPr>
        <p:spPr>
          <a:xfrm>
            <a:off x="0" y="981623"/>
            <a:ext cx="201390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lnSpc>
                <a:spcPct val="120000"/>
              </a:lnSpc>
              <a:buClr>
                <a:schemeClr val="bg2">
                  <a:lumMod val="50000"/>
                </a:schemeClr>
              </a:buClr>
              <a:buFont typeface="Wingdings" pitchFamily="2" charset="2"/>
              <a:buChar char="Ø"/>
            </a:pPr>
            <a:r>
              <a:rPr lang="en-GB" sz="500" smtClean="0">
                <a:latin typeface="Helvetica"/>
                <a:cs typeface="Times New Roman" pitchFamily="18" charset="0"/>
              </a:rPr>
              <a:t>Clostridioides difficile is the main cause of nosocomial diarrhoea. </a:t>
            </a:r>
          </a:p>
          <a:p>
            <a:pPr marL="342900" indent="-342900">
              <a:lnSpc>
                <a:spcPct val="120000"/>
              </a:lnSpc>
              <a:buClr>
                <a:schemeClr val="bg2">
                  <a:lumMod val="50000"/>
                </a:schemeClr>
              </a:buClr>
              <a:buFont typeface="Wingdings" pitchFamily="2" charset="2"/>
              <a:buChar char="Ø"/>
            </a:pPr>
            <a:r>
              <a:rPr lang="en-GB" sz="500" smtClean="0">
                <a:latin typeface="Helvetica"/>
                <a:cs typeface="Times New Roman" pitchFamily="18" charset="0"/>
              </a:rPr>
              <a:t>Approximately 20% of CDI patients will have a recurrent CDI episode (R-CDI). </a:t>
            </a:r>
          </a:p>
          <a:p>
            <a:pPr marL="342900" indent="-342900">
              <a:lnSpc>
                <a:spcPct val="120000"/>
              </a:lnSpc>
              <a:buClr>
                <a:schemeClr val="bg2">
                  <a:lumMod val="50000"/>
                </a:schemeClr>
              </a:buClr>
              <a:buFont typeface="Wingdings" pitchFamily="2" charset="2"/>
              <a:buChar char="Ø"/>
            </a:pPr>
            <a:r>
              <a:rPr lang="en-GB" sz="500" smtClean="0">
                <a:latin typeface="Helvetica"/>
                <a:cs typeface="Times New Roman" pitchFamily="18" charset="0"/>
              </a:rPr>
              <a:t>Identifying biological risk markers for R-CDI is important for proper treatment and prevention. </a:t>
            </a:r>
          </a:p>
          <a:p>
            <a:pPr marL="342900" indent="-342900">
              <a:lnSpc>
                <a:spcPct val="120000"/>
              </a:lnSpc>
              <a:buClr>
                <a:schemeClr val="bg2">
                  <a:lumMod val="50000"/>
                </a:schemeClr>
              </a:buClr>
              <a:buFont typeface="Wingdings" pitchFamily="2" charset="2"/>
              <a:buChar char="Ø"/>
            </a:pPr>
            <a:r>
              <a:rPr lang="en-GB" sz="500" smtClean="0">
                <a:latin typeface="Helvetica"/>
                <a:cs typeface="Times New Roman" pitchFamily="18" charset="0"/>
              </a:rPr>
              <a:t>Calprotectin is a reliable biomarker of inflammatory processes.</a:t>
            </a:r>
            <a:endParaRPr lang="en-GB" sz="500" dirty="0" smtClean="0">
              <a:latin typeface="Helvetica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176782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53" grpId="0">
        <p:bldAsOne/>
      </p:bldGraphic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55</TotalTime>
  <Words>205</Words>
  <Application>Microsoft Macintosh PowerPoint</Application>
  <PresentationFormat>Personalizado</PresentationFormat>
  <Paragraphs>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ilvia.Vazquez</cp:lastModifiedBy>
  <cp:revision>65</cp:revision>
  <dcterms:created xsi:type="dcterms:W3CDTF">2022-06-06T18:41:53Z</dcterms:created>
  <dcterms:modified xsi:type="dcterms:W3CDTF">2023-07-04T08:26:36Z</dcterms:modified>
</cp:coreProperties>
</file>